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0" d="100"/>
          <a:sy n="130" d="100"/>
        </p:scale>
        <p:origin x="-1038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748403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67576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706201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05986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574323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619339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659354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062412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92389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59107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723379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75567-58A7-4F3C-9707-54ABBD2176DB}" type="datetimeFigureOut">
              <a:rPr kumimoji="1" lang="ja-JP" altLang="en-US" smtClean="0"/>
              <a:pPr/>
              <a:t>2024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55C9A5-15D1-4A59-B37D-1F8AEFA129A2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4355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540" y="168194"/>
            <a:ext cx="2854296" cy="21554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465850" y="166866"/>
            <a:ext cx="2879233" cy="21512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60410" y="166866"/>
            <a:ext cx="2970673" cy="21592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899564" y="174862"/>
            <a:ext cx="2776451" cy="21512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07572" y="2072583"/>
            <a:ext cx="2834640" cy="19593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477194" y="2080581"/>
            <a:ext cx="2851264" cy="19513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665133" y="2109087"/>
            <a:ext cx="2971799" cy="19386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907876" y="2080581"/>
            <a:ext cx="2759826" cy="1959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15884" y="3837974"/>
            <a:ext cx="2842952" cy="2047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" name="Picture 12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482476" y="3829977"/>
            <a:ext cx="2845982" cy="20653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688379" y="3829976"/>
            <a:ext cx="2942706" cy="2079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6912104" y="3837975"/>
            <a:ext cx="2771168" cy="2079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0AF16403-6A18-86F3-6ED9-218D970C86E1}"/>
              </a:ext>
            </a:extLst>
          </p:cNvPr>
          <p:cNvSpPr txBox="1"/>
          <p:nvPr/>
        </p:nvSpPr>
        <p:spPr>
          <a:xfrm>
            <a:off x="5155440" y="2045821"/>
            <a:ext cx="1579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umben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98C919ED-186D-93E7-D672-42DAA25824F5}"/>
              </a:ext>
            </a:extLst>
          </p:cNvPr>
          <p:cNvSpPr txBox="1"/>
          <p:nvPr/>
        </p:nvSpPr>
        <p:spPr>
          <a:xfrm>
            <a:off x="3159970" y="3831669"/>
            <a:ext cx="1217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ietal cortex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167EF964-3C0A-FB92-F018-F7E7F408F29E}"/>
              </a:ext>
            </a:extLst>
          </p:cNvPr>
          <p:cNvSpPr txBox="1"/>
          <p:nvPr/>
        </p:nvSpPr>
        <p:spPr>
          <a:xfrm>
            <a:off x="5318463" y="3831669"/>
            <a:ext cx="12971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ccipital cortex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3945BDCB-6BCE-DC52-F02F-6EF781BE269E}"/>
              </a:ext>
            </a:extLst>
          </p:cNvPr>
          <p:cNvSpPr txBox="1"/>
          <p:nvPr/>
        </p:nvSpPr>
        <p:spPr>
          <a:xfrm>
            <a:off x="628310" y="3831669"/>
            <a:ext cx="18101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teral temporal cortex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AED91218-3344-D812-1C75-A85794ED4A20}"/>
              </a:ext>
            </a:extLst>
          </p:cNvPr>
          <p:cNvSpPr txBox="1"/>
          <p:nvPr/>
        </p:nvSpPr>
        <p:spPr>
          <a:xfrm>
            <a:off x="7244958" y="3831669"/>
            <a:ext cx="1699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frontal cortex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B3EFD510-AB71-9F39-E31A-A380192C7C8E}"/>
              </a:ext>
            </a:extLst>
          </p:cNvPr>
          <p:cNvSpPr txBox="1"/>
          <p:nvPr/>
        </p:nvSpPr>
        <p:spPr>
          <a:xfrm>
            <a:off x="959547" y="131713"/>
            <a:ext cx="10374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brai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E4B38B47-55C6-8265-DDD4-C8665C1DDE05}"/>
              </a:ext>
            </a:extLst>
          </p:cNvPr>
          <p:cNvSpPr txBox="1"/>
          <p:nvPr/>
        </p:nvSpPr>
        <p:spPr>
          <a:xfrm>
            <a:off x="3447441" y="131713"/>
            <a:ext cx="5245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n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C0EEC8A6-E098-CA03-7B51-03D5337E2DD5}"/>
              </a:ext>
            </a:extLst>
          </p:cNvPr>
          <p:cNvSpPr txBox="1"/>
          <p:nvPr/>
        </p:nvSpPr>
        <p:spPr>
          <a:xfrm>
            <a:off x="5518138" y="131713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brai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53576A4E-B0E8-66C4-CDE0-826AD9BD9360}"/>
              </a:ext>
            </a:extLst>
          </p:cNvPr>
          <p:cNvSpPr txBox="1"/>
          <p:nvPr/>
        </p:nvSpPr>
        <p:spPr>
          <a:xfrm>
            <a:off x="7630503" y="131713"/>
            <a:ext cx="833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lamu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1DA382E0-DDC3-AC7D-7CF9-4D0BCF6A5F7E}"/>
              </a:ext>
            </a:extLst>
          </p:cNvPr>
          <p:cNvSpPr txBox="1"/>
          <p:nvPr/>
        </p:nvSpPr>
        <p:spPr>
          <a:xfrm>
            <a:off x="3261203" y="2027103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tamen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DFC377B0-068F-495C-698D-3B391BC5095E}"/>
              </a:ext>
            </a:extLst>
          </p:cNvPr>
          <p:cNvSpPr txBox="1"/>
          <p:nvPr/>
        </p:nvSpPr>
        <p:spPr>
          <a:xfrm>
            <a:off x="1155532" y="2027103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udate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67C9F250-ECDA-4B06-942C-E9C9B4DD7067}"/>
              </a:ext>
            </a:extLst>
          </p:cNvPr>
          <p:cNvSpPr txBox="1"/>
          <p:nvPr/>
        </p:nvSpPr>
        <p:spPr>
          <a:xfrm>
            <a:off x="7599165" y="2027103"/>
            <a:ext cx="9140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cuneus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xmlns="" id="{0BDD485B-2985-4AF9-7E78-C25EA59BAED2}"/>
              </a:ext>
            </a:extLst>
          </p:cNvPr>
          <p:cNvGrpSpPr/>
          <p:nvPr/>
        </p:nvGrpSpPr>
        <p:grpSpPr>
          <a:xfrm>
            <a:off x="934673" y="761535"/>
            <a:ext cx="1224000" cy="55146"/>
            <a:chOff x="915623" y="1104729"/>
            <a:chExt cx="1224000" cy="57321"/>
          </a:xfrm>
        </p:grpSpPr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xmlns="" id="{4E90AFAF-9F91-F9BF-8828-F774997269DF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xmlns="" id="{803ECC58-75D6-8C6A-1BE0-16BDA25A9618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xmlns="" id="{CF0BAFC0-23FF-0F75-7392-7E905FEF0E96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xmlns="" id="{39F6C9B0-42CA-CF4B-6E16-A1A7D83A0E89}"/>
              </a:ext>
            </a:extLst>
          </p:cNvPr>
          <p:cNvSpPr txBox="1"/>
          <p:nvPr/>
        </p:nvSpPr>
        <p:spPr>
          <a:xfrm>
            <a:off x="575615" y="905692"/>
            <a:ext cx="10871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6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9D1F0273-AC23-4B93-830A-5529B0ED441F}"/>
              </a:ext>
            </a:extLst>
          </p:cNvPr>
          <p:cNvSpPr txBox="1"/>
          <p:nvPr/>
        </p:nvSpPr>
        <p:spPr>
          <a:xfrm>
            <a:off x="1677241" y="909714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xmlns="" id="{565E3B71-7699-C9A6-C6EF-F8E010E4A809}"/>
              </a:ext>
            </a:extLst>
          </p:cNvPr>
          <p:cNvGrpSpPr/>
          <p:nvPr/>
        </p:nvGrpSpPr>
        <p:grpSpPr>
          <a:xfrm>
            <a:off x="930439" y="1098259"/>
            <a:ext cx="793229" cy="38399"/>
            <a:chOff x="5352044" y="5319294"/>
            <a:chExt cx="793229" cy="39913"/>
          </a:xfrm>
        </p:grpSpPr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xmlns="" id="{005B4B65-EA8C-93A0-E49E-6A89DE205D6D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:a16="http://schemas.microsoft.com/office/drawing/2014/main" xmlns="" id="{B8E19DAA-2A62-CD34-21FD-8885516E57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xmlns="" id="{90DC7F68-572D-55B9-D9F6-B8B13801F912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xmlns="" id="{0723EBAB-45B9-0692-6059-DE65BDA887E6}"/>
              </a:ext>
            </a:extLst>
          </p:cNvPr>
          <p:cNvSpPr txBox="1"/>
          <p:nvPr/>
        </p:nvSpPr>
        <p:spPr>
          <a:xfrm>
            <a:off x="1242414" y="56341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lvl="1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xmlns="" id="{30CC4B2A-6264-7A18-C1BF-3410E193BEA5}"/>
              </a:ext>
            </a:extLst>
          </p:cNvPr>
          <p:cNvGrpSpPr/>
          <p:nvPr/>
        </p:nvGrpSpPr>
        <p:grpSpPr>
          <a:xfrm>
            <a:off x="1753361" y="1100164"/>
            <a:ext cx="397229" cy="38399"/>
            <a:chOff x="5352044" y="5319294"/>
            <a:chExt cx="397229" cy="39913"/>
          </a:xfrm>
        </p:grpSpPr>
        <p:cxnSp>
          <p:nvCxnSpPr>
            <p:cNvPr id="92" name="直線コネクタ 91">
              <a:extLst>
                <a:ext uri="{FF2B5EF4-FFF2-40B4-BE49-F238E27FC236}">
                  <a16:creationId xmlns:a16="http://schemas.microsoft.com/office/drawing/2014/main" xmlns="" id="{6B3DE385-040B-0FB4-F462-477D5C8CC9C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xmlns="" id="{20A89199-2069-2A86-040C-704D9CFD01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xmlns="" id="{0A35F625-7F23-7578-F126-8EDB19F4AB41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xmlns="" id="{D7BFD6CE-08F5-BDA8-5949-D24E3E394318}"/>
              </a:ext>
            </a:extLst>
          </p:cNvPr>
          <p:cNvSpPr txBox="1"/>
          <p:nvPr/>
        </p:nvSpPr>
        <p:spPr>
          <a:xfrm>
            <a:off x="1424309" y="726603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xmlns="" id="{46969C69-D2DB-1524-1D39-E05E81617AE9}"/>
              </a:ext>
            </a:extLst>
          </p:cNvPr>
          <p:cNvGrpSpPr/>
          <p:nvPr/>
        </p:nvGrpSpPr>
        <p:grpSpPr>
          <a:xfrm>
            <a:off x="1347532" y="897047"/>
            <a:ext cx="793229" cy="38399"/>
            <a:chOff x="5352044" y="5319294"/>
            <a:chExt cx="793229" cy="39913"/>
          </a:xfrm>
        </p:grpSpPr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xmlns="" id="{0DD595B8-D2F5-D07D-70D7-3EB558CB2A0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xmlns="" id="{9C8F58C9-7691-D93D-C3AB-9DE961CE61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xmlns="" id="{B1903644-1F1A-A2EC-AA04-FA19776EC83D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3" name="グループ化 112">
            <a:extLst>
              <a:ext uri="{FF2B5EF4-FFF2-40B4-BE49-F238E27FC236}">
                <a16:creationId xmlns:a16="http://schemas.microsoft.com/office/drawing/2014/main" xmlns="" id="{813DB8A1-253B-9AD2-F438-7D792694BD44}"/>
              </a:ext>
            </a:extLst>
          </p:cNvPr>
          <p:cNvGrpSpPr/>
          <p:nvPr/>
        </p:nvGrpSpPr>
        <p:grpSpPr>
          <a:xfrm>
            <a:off x="3530165" y="776333"/>
            <a:ext cx="793229" cy="38399"/>
            <a:chOff x="5352044" y="5319294"/>
            <a:chExt cx="793229" cy="39913"/>
          </a:xfrm>
        </p:grpSpPr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xmlns="" id="{0B45A3DA-C3F8-2960-3490-708D95DC083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直線コネクタ 114">
              <a:extLst>
                <a:ext uri="{FF2B5EF4-FFF2-40B4-BE49-F238E27FC236}">
                  <a16:creationId xmlns:a16="http://schemas.microsoft.com/office/drawing/2014/main" xmlns="" id="{0ED2CA7A-7121-D2DA-0FCE-5AB25213D91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xmlns="" id="{9BC3C8A7-7BBC-3393-B6FF-3EF397E0BFB3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xmlns="" id="{FC173B1B-1781-D6C2-47CA-0211850EAEA8}"/>
              </a:ext>
            </a:extLst>
          </p:cNvPr>
          <p:cNvGrpSpPr/>
          <p:nvPr/>
        </p:nvGrpSpPr>
        <p:grpSpPr>
          <a:xfrm>
            <a:off x="3535122" y="959346"/>
            <a:ext cx="397229" cy="38399"/>
            <a:chOff x="5352044" y="5319294"/>
            <a:chExt cx="397229" cy="39913"/>
          </a:xfrm>
        </p:grpSpPr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xmlns="" id="{EEC86C41-3D3D-B62A-B4BB-35D9C681A103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" name="直線コネクタ 120">
              <a:extLst>
                <a:ext uri="{FF2B5EF4-FFF2-40B4-BE49-F238E27FC236}">
                  <a16:creationId xmlns:a16="http://schemas.microsoft.com/office/drawing/2014/main" xmlns="" id="{C69C9CA8-DB60-B743-5B06-A5C7DFE92B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xmlns="" id="{447B96EE-2D1C-3292-8C89-3CAF20697357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xmlns="" id="{5ED04884-CC93-165C-5675-2D0D323CEA41}"/>
              </a:ext>
            </a:extLst>
          </p:cNvPr>
          <p:cNvSpPr txBox="1"/>
          <p:nvPr/>
        </p:nvSpPr>
        <p:spPr>
          <a:xfrm>
            <a:off x="3618320" y="601971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xmlns="" id="{EFF2D116-B820-FF36-3F24-2701A477DE23}"/>
              </a:ext>
            </a:extLst>
          </p:cNvPr>
          <p:cNvSpPr txBox="1"/>
          <p:nvPr/>
        </p:nvSpPr>
        <p:spPr>
          <a:xfrm>
            <a:off x="3408968" y="786010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2" name="テキスト ボックス 1031">
            <a:extLst>
              <a:ext uri="{FF2B5EF4-FFF2-40B4-BE49-F238E27FC236}">
                <a16:creationId xmlns:a16="http://schemas.microsoft.com/office/drawing/2014/main" xmlns="" id="{80C922A0-EE37-3F81-C6EB-5A1F953DD307}"/>
              </a:ext>
            </a:extLst>
          </p:cNvPr>
          <p:cNvSpPr txBox="1"/>
          <p:nvPr/>
        </p:nvSpPr>
        <p:spPr>
          <a:xfrm>
            <a:off x="3405556" y="44338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34" name="グループ化 1033">
            <a:extLst>
              <a:ext uri="{FF2B5EF4-FFF2-40B4-BE49-F238E27FC236}">
                <a16:creationId xmlns:a16="http://schemas.microsoft.com/office/drawing/2014/main" xmlns="" id="{26AC4854-3057-A828-1FDF-DBED657EEE82}"/>
              </a:ext>
            </a:extLst>
          </p:cNvPr>
          <p:cNvGrpSpPr/>
          <p:nvPr/>
        </p:nvGrpSpPr>
        <p:grpSpPr>
          <a:xfrm>
            <a:off x="3105400" y="616800"/>
            <a:ext cx="1224000" cy="55146"/>
            <a:chOff x="915623" y="1104729"/>
            <a:chExt cx="1224000" cy="57321"/>
          </a:xfrm>
        </p:grpSpPr>
        <p:cxnSp>
          <p:nvCxnSpPr>
            <p:cNvPr id="1036" name="直線コネクタ 1035">
              <a:extLst>
                <a:ext uri="{FF2B5EF4-FFF2-40B4-BE49-F238E27FC236}">
                  <a16:creationId xmlns:a16="http://schemas.microsoft.com/office/drawing/2014/main" xmlns="" id="{3166FC92-FFE1-2016-17D4-48FE37BBB53F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39" name="直線コネクタ 1038">
              <a:extLst>
                <a:ext uri="{FF2B5EF4-FFF2-40B4-BE49-F238E27FC236}">
                  <a16:creationId xmlns:a16="http://schemas.microsoft.com/office/drawing/2014/main" xmlns="" id="{303AE3EC-3125-670A-8ED3-B74CADA4E5C7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0" name="直線コネクタ 1039">
              <a:extLst>
                <a:ext uri="{FF2B5EF4-FFF2-40B4-BE49-F238E27FC236}">
                  <a16:creationId xmlns:a16="http://schemas.microsoft.com/office/drawing/2014/main" xmlns="" id="{991A07A4-5E8A-3AF9-AF53-A324F6C72405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42" name="テキスト ボックス 1041">
            <a:extLst>
              <a:ext uri="{FF2B5EF4-FFF2-40B4-BE49-F238E27FC236}">
                <a16:creationId xmlns:a16="http://schemas.microsoft.com/office/drawing/2014/main" xmlns="" id="{076931A7-FFD7-C5F3-1695-7C86498812B6}"/>
              </a:ext>
            </a:extLst>
          </p:cNvPr>
          <p:cNvSpPr txBox="1"/>
          <p:nvPr/>
        </p:nvSpPr>
        <p:spPr>
          <a:xfrm>
            <a:off x="5656807" y="355768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8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43" name="グループ化 1042">
            <a:extLst>
              <a:ext uri="{FF2B5EF4-FFF2-40B4-BE49-F238E27FC236}">
                <a16:creationId xmlns:a16="http://schemas.microsoft.com/office/drawing/2014/main" xmlns="" id="{0C7DD074-80CF-3BA1-770F-4BD4E75F4BF5}"/>
              </a:ext>
            </a:extLst>
          </p:cNvPr>
          <p:cNvGrpSpPr/>
          <p:nvPr/>
        </p:nvGrpSpPr>
        <p:grpSpPr>
          <a:xfrm>
            <a:off x="5337200" y="524751"/>
            <a:ext cx="1224000" cy="55146"/>
            <a:chOff x="915623" y="1104729"/>
            <a:chExt cx="1224000" cy="57321"/>
          </a:xfrm>
        </p:grpSpPr>
        <p:cxnSp>
          <p:nvCxnSpPr>
            <p:cNvPr id="1044" name="直線コネクタ 1043">
              <a:extLst>
                <a:ext uri="{FF2B5EF4-FFF2-40B4-BE49-F238E27FC236}">
                  <a16:creationId xmlns:a16="http://schemas.microsoft.com/office/drawing/2014/main" xmlns="" id="{FACAB5F3-3EEB-52D3-F59A-18C16EDACFA2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5" name="直線コネクタ 1044">
              <a:extLst>
                <a:ext uri="{FF2B5EF4-FFF2-40B4-BE49-F238E27FC236}">
                  <a16:creationId xmlns:a16="http://schemas.microsoft.com/office/drawing/2014/main" xmlns="" id="{E27660D7-2753-A811-82A1-54853D56E3E9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6" name="直線コネクタ 1045">
              <a:extLst>
                <a:ext uri="{FF2B5EF4-FFF2-40B4-BE49-F238E27FC236}">
                  <a16:creationId xmlns:a16="http://schemas.microsoft.com/office/drawing/2014/main" xmlns="" id="{45120657-8C60-FE89-7FD6-4A8AE486BACB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47" name="グループ化 1046">
            <a:extLst>
              <a:ext uri="{FF2B5EF4-FFF2-40B4-BE49-F238E27FC236}">
                <a16:creationId xmlns:a16="http://schemas.microsoft.com/office/drawing/2014/main" xmlns="" id="{7099B1A4-DAF4-601A-3F03-BC5B5779A1EB}"/>
              </a:ext>
            </a:extLst>
          </p:cNvPr>
          <p:cNvGrpSpPr/>
          <p:nvPr/>
        </p:nvGrpSpPr>
        <p:grpSpPr>
          <a:xfrm>
            <a:off x="5752234" y="656215"/>
            <a:ext cx="793229" cy="38399"/>
            <a:chOff x="5352044" y="5319294"/>
            <a:chExt cx="793229" cy="39913"/>
          </a:xfrm>
        </p:grpSpPr>
        <p:cxnSp>
          <p:nvCxnSpPr>
            <p:cNvPr id="1048" name="直線コネクタ 1047">
              <a:extLst>
                <a:ext uri="{FF2B5EF4-FFF2-40B4-BE49-F238E27FC236}">
                  <a16:creationId xmlns:a16="http://schemas.microsoft.com/office/drawing/2014/main" xmlns="" id="{B9A969BB-4BF2-78DA-C1A7-F70458595494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9" name="直線コネクタ 1048">
              <a:extLst>
                <a:ext uri="{FF2B5EF4-FFF2-40B4-BE49-F238E27FC236}">
                  <a16:creationId xmlns:a16="http://schemas.microsoft.com/office/drawing/2014/main" xmlns="" id="{02E568B4-013C-6993-09C6-24A4CBF0437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0" name="直線コネクタ 1049">
              <a:extLst>
                <a:ext uri="{FF2B5EF4-FFF2-40B4-BE49-F238E27FC236}">
                  <a16:creationId xmlns:a16="http://schemas.microsoft.com/office/drawing/2014/main" xmlns="" id="{7AEE1B68-B29D-ABA8-E5EC-9BAF927A0432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51" name="グループ化 1050">
            <a:extLst>
              <a:ext uri="{FF2B5EF4-FFF2-40B4-BE49-F238E27FC236}">
                <a16:creationId xmlns:a16="http://schemas.microsoft.com/office/drawing/2014/main" xmlns="" id="{A3F7A5B7-431B-4FC2-F4FC-AF99D4710F3C}"/>
              </a:ext>
            </a:extLst>
          </p:cNvPr>
          <p:cNvGrpSpPr/>
          <p:nvPr/>
        </p:nvGrpSpPr>
        <p:grpSpPr>
          <a:xfrm>
            <a:off x="6144882" y="795925"/>
            <a:ext cx="397229" cy="38399"/>
            <a:chOff x="5352044" y="5319294"/>
            <a:chExt cx="397229" cy="39913"/>
          </a:xfrm>
        </p:grpSpPr>
        <p:cxnSp>
          <p:nvCxnSpPr>
            <p:cNvPr id="1052" name="直線コネクタ 1051">
              <a:extLst>
                <a:ext uri="{FF2B5EF4-FFF2-40B4-BE49-F238E27FC236}">
                  <a16:creationId xmlns:a16="http://schemas.microsoft.com/office/drawing/2014/main" xmlns="" id="{2FC7F7CF-10C4-BC91-DCA2-BF3F00BC8058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3" name="直線コネクタ 1052">
              <a:extLst>
                <a:ext uri="{FF2B5EF4-FFF2-40B4-BE49-F238E27FC236}">
                  <a16:creationId xmlns:a16="http://schemas.microsoft.com/office/drawing/2014/main" xmlns="" id="{6CA0B797-4AF1-87E4-CAF2-6599F1D571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54" name="直線コネクタ 1053">
              <a:extLst>
                <a:ext uri="{FF2B5EF4-FFF2-40B4-BE49-F238E27FC236}">
                  <a16:creationId xmlns:a16="http://schemas.microsoft.com/office/drawing/2014/main" xmlns="" id="{603B4FB1-013E-1D86-B890-F197414E5AC7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55" name="テキスト ボックス 1054">
            <a:extLst>
              <a:ext uri="{FF2B5EF4-FFF2-40B4-BE49-F238E27FC236}">
                <a16:creationId xmlns:a16="http://schemas.microsoft.com/office/drawing/2014/main" xmlns="" id="{85C920B4-5D18-CA52-04E6-80A0DBF770E9}"/>
              </a:ext>
            </a:extLst>
          </p:cNvPr>
          <p:cNvSpPr txBox="1"/>
          <p:nvPr/>
        </p:nvSpPr>
        <p:spPr>
          <a:xfrm>
            <a:off x="5772296" y="48627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6" name="テキスト ボックス 1055">
            <a:extLst>
              <a:ext uri="{FF2B5EF4-FFF2-40B4-BE49-F238E27FC236}">
                <a16:creationId xmlns:a16="http://schemas.microsoft.com/office/drawing/2014/main" xmlns="" id="{99AE5420-9B0A-5A82-7AE2-A1A245B83198}"/>
              </a:ext>
            </a:extLst>
          </p:cNvPr>
          <p:cNvSpPr txBox="1"/>
          <p:nvPr/>
        </p:nvSpPr>
        <p:spPr>
          <a:xfrm>
            <a:off x="6035901" y="628190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58" name="グループ化 1057">
            <a:extLst>
              <a:ext uri="{FF2B5EF4-FFF2-40B4-BE49-F238E27FC236}">
                <a16:creationId xmlns:a16="http://schemas.microsoft.com/office/drawing/2014/main" xmlns="" id="{AE279513-1DF4-6DF6-6476-56A54812FAFF}"/>
              </a:ext>
            </a:extLst>
          </p:cNvPr>
          <p:cNvGrpSpPr/>
          <p:nvPr/>
        </p:nvGrpSpPr>
        <p:grpSpPr>
          <a:xfrm>
            <a:off x="7492568" y="498603"/>
            <a:ext cx="1224000" cy="55146"/>
            <a:chOff x="915623" y="1104729"/>
            <a:chExt cx="1224000" cy="57321"/>
          </a:xfrm>
        </p:grpSpPr>
        <p:cxnSp>
          <p:nvCxnSpPr>
            <p:cNvPr id="1059" name="直線コネクタ 1058">
              <a:extLst>
                <a:ext uri="{FF2B5EF4-FFF2-40B4-BE49-F238E27FC236}">
                  <a16:creationId xmlns:a16="http://schemas.microsoft.com/office/drawing/2014/main" xmlns="" id="{103C5164-0279-DF55-341A-8C5B5AD3F56C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0" name="直線コネクタ 1059">
              <a:extLst>
                <a:ext uri="{FF2B5EF4-FFF2-40B4-BE49-F238E27FC236}">
                  <a16:creationId xmlns:a16="http://schemas.microsoft.com/office/drawing/2014/main" xmlns="" id="{70ACCF81-6A15-D0E5-BCA2-719CDDA2B95F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1" name="直線コネクタ 1060">
              <a:extLst>
                <a:ext uri="{FF2B5EF4-FFF2-40B4-BE49-F238E27FC236}">
                  <a16:creationId xmlns:a16="http://schemas.microsoft.com/office/drawing/2014/main" xmlns="" id="{BE5309E3-D1C0-4528-B77E-74132CC34464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62" name="グループ化 1061">
            <a:extLst>
              <a:ext uri="{FF2B5EF4-FFF2-40B4-BE49-F238E27FC236}">
                <a16:creationId xmlns:a16="http://schemas.microsoft.com/office/drawing/2014/main" xmlns="" id="{9549FE83-32EA-4ABA-8D94-608C10B37F84}"/>
              </a:ext>
            </a:extLst>
          </p:cNvPr>
          <p:cNvGrpSpPr/>
          <p:nvPr/>
        </p:nvGrpSpPr>
        <p:grpSpPr>
          <a:xfrm>
            <a:off x="7494632" y="727849"/>
            <a:ext cx="793229" cy="38399"/>
            <a:chOff x="5352044" y="5319294"/>
            <a:chExt cx="793229" cy="39913"/>
          </a:xfrm>
        </p:grpSpPr>
        <p:cxnSp>
          <p:nvCxnSpPr>
            <p:cNvPr id="1063" name="直線コネクタ 1062">
              <a:extLst>
                <a:ext uri="{FF2B5EF4-FFF2-40B4-BE49-F238E27FC236}">
                  <a16:creationId xmlns:a16="http://schemas.microsoft.com/office/drawing/2014/main" xmlns="" id="{FC1B2212-0E82-BF5B-B872-D77EE422758F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4" name="直線コネクタ 1063">
              <a:extLst>
                <a:ext uri="{FF2B5EF4-FFF2-40B4-BE49-F238E27FC236}">
                  <a16:creationId xmlns:a16="http://schemas.microsoft.com/office/drawing/2014/main" xmlns="" id="{F368C755-EE3B-D3D4-0E4A-623880C25D7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5" name="直線コネクタ 1064">
              <a:extLst>
                <a:ext uri="{FF2B5EF4-FFF2-40B4-BE49-F238E27FC236}">
                  <a16:creationId xmlns:a16="http://schemas.microsoft.com/office/drawing/2014/main" xmlns="" id="{58E78A34-4702-0A7A-445B-AE9F57F4839D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66" name="グループ化 1065">
            <a:extLst>
              <a:ext uri="{FF2B5EF4-FFF2-40B4-BE49-F238E27FC236}">
                <a16:creationId xmlns:a16="http://schemas.microsoft.com/office/drawing/2014/main" xmlns="" id="{9847BDB9-271B-B6A6-8F8B-38D9B4A5D930}"/>
              </a:ext>
            </a:extLst>
          </p:cNvPr>
          <p:cNvGrpSpPr/>
          <p:nvPr/>
        </p:nvGrpSpPr>
        <p:grpSpPr>
          <a:xfrm>
            <a:off x="8324083" y="728541"/>
            <a:ext cx="397229" cy="38399"/>
            <a:chOff x="5352044" y="5319294"/>
            <a:chExt cx="397229" cy="39913"/>
          </a:xfrm>
        </p:grpSpPr>
        <p:cxnSp>
          <p:nvCxnSpPr>
            <p:cNvPr id="1067" name="直線コネクタ 1066">
              <a:extLst>
                <a:ext uri="{FF2B5EF4-FFF2-40B4-BE49-F238E27FC236}">
                  <a16:creationId xmlns:a16="http://schemas.microsoft.com/office/drawing/2014/main" xmlns="" id="{8A27FEA6-0AA0-6AF8-50AA-66A4041560BA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8" name="直線コネクタ 1067">
              <a:extLst>
                <a:ext uri="{FF2B5EF4-FFF2-40B4-BE49-F238E27FC236}">
                  <a16:creationId xmlns:a16="http://schemas.microsoft.com/office/drawing/2014/main" xmlns="" id="{95A047C7-73C5-5E38-86C6-F0662F01D4E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69" name="直線コネクタ 1068">
              <a:extLst>
                <a:ext uri="{FF2B5EF4-FFF2-40B4-BE49-F238E27FC236}">
                  <a16:creationId xmlns:a16="http://schemas.microsoft.com/office/drawing/2014/main" xmlns="" id="{F2275950-F450-7DE6-AE7F-FAE9294AD718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70" name="テキスト ボックス 1069">
            <a:extLst>
              <a:ext uri="{FF2B5EF4-FFF2-40B4-BE49-F238E27FC236}">
                <a16:creationId xmlns:a16="http://schemas.microsoft.com/office/drawing/2014/main" xmlns="" id="{02DF56E0-9FB9-E7C4-EB70-D778AC885BF8}"/>
              </a:ext>
            </a:extLst>
          </p:cNvPr>
          <p:cNvSpPr txBox="1"/>
          <p:nvPr/>
        </p:nvSpPr>
        <p:spPr>
          <a:xfrm>
            <a:off x="8203038" y="569286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1" name="テキスト ボックス 1070">
            <a:extLst>
              <a:ext uri="{FF2B5EF4-FFF2-40B4-BE49-F238E27FC236}">
                <a16:creationId xmlns:a16="http://schemas.microsoft.com/office/drawing/2014/main" xmlns="" id="{0E00A367-BCB5-6E17-7CB6-C96961E5B90C}"/>
              </a:ext>
            </a:extLst>
          </p:cNvPr>
          <p:cNvSpPr txBox="1"/>
          <p:nvPr/>
        </p:nvSpPr>
        <p:spPr>
          <a:xfrm>
            <a:off x="7360841" y="567126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0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72" name="グループ化 1071">
            <a:extLst>
              <a:ext uri="{FF2B5EF4-FFF2-40B4-BE49-F238E27FC236}">
                <a16:creationId xmlns:a16="http://schemas.microsoft.com/office/drawing/2014/main" xmlns="" id="{62EA5191-14BD-EEF2-2E12-A4FBED4B3689}"/>
              </a:ext>
            </a:extLst>
          </p:cNvPr>
          <p:cNvGrpSpPr/>
          <p:nvPr/>
        </p:nvGrpSpPr>
        <p:grpSpPr>
          <a:xfrm>
            <a:off x="7935620" y="905316"/>
            <a:ext cx="360000" cy="39427"/>
            <a:chOff x="5350892" y="5318225"/>
            <a:chExt cx="360000" cy="40982"/>
          </a:xfrm>
        </p:grpSpPr>
        <p:cxnSp>
          <p:nvCxnSpPr>
            <p:cNvPr id="1073" name="直線コネクタ 1072">
              <a:extLst>
                <a:ext uri="{FF2B5EF4-FFF2-40B4-BE49-F238E27FC236}">
                  <a16:creationId xmlns:a16="http://schemas.microsoft.com/office/drawing/2014/main" xmlns="" id="{441E075B-0CFC-28F4-0C2E-AD958B3FD2DE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4" name="直線コネクタ 1073">
              <a:extLst>
                <a:ext uri="{FF2B5EF4-FFF2-40B4-BE49-F238E27FC236}">
                  <a16:creationId xmlns:a16="http://schemas.microsoft.com/office/drawing/2014/main" xmlns="" id="{9AFD3835-86FB-9ECF-DF16-383793D5084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08731" y="5318225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5" name="直線コネクタ 1074">
              <a:extLst>
                <a:ext uri="{FF2B5EF4-FFF2-40B4-BE49-F238E27FC236}">
                  <a16:creationId xmlns:a16="http://schemas.microsoft.com/office/drawing/2014/main" xmlns="" id="{1356E195-AE70-65D3-A652-AAA0DCDA8A3E}"/>
                </a:ext>
              </a:extLst>
            </p:cNvPr>
            <p:cNvCxnSpPr/>
            <p:nvPr/>
          </p:nvCxnSpPr>
          <p:spPr>
            <a:xfrm flipV="1">
              <a:off x="5350892" y="5319294"/>
              <a:ext cx="360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76" name="グループ化 1075">
            <a:extLst>
              <a:ext uri="{FF2B5EF4-FFF2-40B4-BE49-F238E27FC236}">
                <a16:creationId xmlns:a16="http://schemas.microsoft.com/office/drawing/2014/main" xmlns="" id="{3DD3F98D-6356-BA34-166A-EEE233898A38}"/>
              </a:ext>
            </a:extLst>
          </p:cNvPr>
          <p:cNvGrpSpPr/>
          <p:nvPr/>
        </p:nvGrpSpPr>
        <p:grpSpPr>
          <a:xfrm>
            <a:off x="7921618" y="608647"/>
            <a:ext cx="793229" cy="38399"/>
            <a:chOff x="5352044" y="5319294"/>
            <a:chExt cx="793229" cy="39913"/>
          </a:xfrm>
        </p:grpSpPr>
        <p:cxnSp>
          <p:nvCxnSpPr>
            <p:cNvPr id="1077" name="直線コネクタ 1076">
              <a:extLst>
                <a:ext uri="{FF2B5EF4-FFF2-40B4-BE49-F238E27FC236}">
                  <a16:creationId xmlns:a16="http://schemas.microsoft.com/office/drawing/2014/main" xmlns="" id="{32EBAA1A-D168-855D-97D8-E7FFADA48990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8" name="直線コネクタ 1077">
              <a:extLst>
                <a:ext uri="{FF2B5EF4-FFF2-40B4-BE49-F238E27FC236}">
                  <a16:creationId xmlns:a16="http://schemas.microsoft.com/office/drawing/2014/main" xmlns="" id="{5D9C0181-FCEE-D210-E6DD-246E7CDA6EE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9" name="直線コネクタ 1078">
              <a:extLst>
                <a:ext uri="{FF2B5EF4-FFF2-40B4-BE49-F238E27FC236}">
                  <a16:creationId xmlns:a16="http://schemas.microsoft.com/office/drawing/2014/main" xmlns="" id="{E6300A43-4109-7926-77BD-23FA46E56109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80" name="テキスト ボックス 1079">
            <a:extLst>
              <a:ext uri="{FF2B5EF4-FFF2-40B4-BE49-F238E27FC236}">
                <a16:creationId xmlns:a16="http://schemas.microsoft.com/office/drawing/2014/main" xmlns="" id="{543ECA66-91B6-9E84-0CD9-EFD896BBFD13}"/>
              </a:ext>
            </a:extLst>
          </p:cNvPr>
          <p:cNvSpPr txBox="1"/>
          <p:nvPr/>
        </p:nvSpPr>
        <p:spPr>
          <a:xfrm>
            <a:off x="7775537" y="327341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1" name="テキスト ボックス 1080">
            <a:extLst>
              <a:ext uri="{FF2B5EF4-FFF2-40B4-BE49-F238E27FC236}">
                <a16:creationId xmlns:a16="http://schemas.microsoft.com/office/drawing/2014/main" xmlns="" id="{17D4F64E-B7F7-460F-3345-33CF459D1DD0}"/>
              </a:ext>
            </a:extLst>
          </p:cNvPr>
          <p:cNvSpPr txBox="1"/>
          <p:nvPr/>
        </p:nvSpPr>
        <p:spPr>
          <a:xfrm>
            <a:off x="7818423" y="721210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6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2" name="テキスト ボックス 1081">
            <a:extLst>
              <a:ext uri="{FF2B5EF4-FFF2-40B4-BE49-F238E27FC236}">
                <a16:creationId xmlns:a16="http://schemas.microsoft.com/office/drawing/2014/main" xmlns="" id="{337CC3CE-AEDE-9430-C2E3-5FA620BD703E}"/>
              </a:ext>
            </a:extLst>
          </p:cNvPr>
          <p:cNvSpPr txBox="1"/>
          <p:nvPr/>
        </p:nvSpPr>
        <p:spPr>
          <a:xfrm>
            <a:off x="7949386" y="448188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83" name="グループ化 1082">
            <a:extLst>
              <a:ext uri="{FF2B5EF4-FFF2-40B4-BE49-F238E27FC236}">
                <a16:creationId xmlns:a16="http://schemas.microsoft.com/office/drawing/2014/main" xmlns="" id="{ACC3D9A7-055D-6F55-E848-6DAA7A718123}"/>
              </a:ext>
            </a:extLst>
          </p:cNvPr>
          <p:cNvGrpSpPr/>
          <p:nvPr/>
        </p:nvGrpSpPr>
        <p:grpSpPr>
          <a:xfrm>
            <a:off x="909094" y="3221619"/>
            <a:ext cx="1224000" cy="55146"/>
            <a:chOff x="915623" y="1104729"/>
            <a:chExt cx="1224000" cy="57321"/>
          </a:xfrm>
        </p:grpSpPr>
        <p:cxnSp>
          <p:nvCxnSpPr>
            <p:cNvPr id="1084" name="直線コネクタ 1083">
              <a:extLst>
                <a:ext uri="{FF2B5EF4-FFF2-40B4-BE49-F238E27FC236}">
                  <a16:creationId xmlns:a16="http://schemas.microsoft.com/office/drawing/2014/main" xmlns="" id="{7BBE4F5A-B1D2-FC98-A6BE-5C2C4D7162CA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5" name="直線コネクタ 1084">
              <a:extLst>
                <a:ext uri="{FF2B5EF4-FFF2-40B4-BE49-F238E27FC236}">
                  <a16:creationId xmlns:a16="http://schemas.microsoft.com/office/drawing/2014/main" xmlns="" id="{87F3AD62-16AE-AA7F-3AF8-D24E5F8FB5D1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6" name="直線コネクタ 1085">
              <a:extLst>
                <a:ext uri="{FF2B5EF4-FFF2-40B4-BE49-F238E27FC236}">
                  <a16:creationId xmlns:a16="http://schemas.microsoft.com/office/drawing/2014/main" xmlns="" id="{25387AEF-6041-674E-7BDC-6CD14847487E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87" name="テキスト ボックス 1086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1192063" y="3050356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88" name="グループ化 1087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1338911" y="3398020"/>
            <a:ext cx="793229" cy="38399"/>
            <a:chOff x="5352044" y="5319294"/>
            <a:chExt cx="793229" cy="39913"/>
          </a:xfrm>
        </p:grpSpPr>
        <p:cxnSp>
          <p:nvCxnSpPr>
            <p:cNvPr id="1089" name="直線コネクタ 1088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0" name="直線コネクタ 1089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91" name="直線コネクタ 1090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92" name="テキスト ボックス 1091">
            <a:extLst>
              <a:ext uri="{FF2B5EF4-FFF2-40B4-BE49-F238E27FC236}">
                <a16:creationId xmlns:a16="http://schemas.microsoft.com/office/drawing/2014/main" xmlns="" id="{B1743B73-F20D-0D0F-63E8-5959A49FD674}"/>
              </a:ext>
            </a:extLst>
          </p:cNvPr>
          <p:cNvSpPr txBox="1"/>
          <p:nvPr/>
        </p:nvSpPr>
        <p:spPr>
          <a:xfrm>
            <a:off x="1428271" y="3223804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7" name="グループ化 136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3109653" y="2720784"/>
            <a:ext cx="793229" cy="38399"/>
            <a:chOff x="5352044" y="5319294"/>
            <a:chExt cx="793229" cy="39913"/>
          </a:xfrm>
        </p:grpSpPr>
        <p:cxnSp>
          <p:nvCxnSpPr>
            <p:cNvPr id="138" name="直線コネクタ 137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9" name="直線コネクタ 138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" name="直線コネクタ 139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1" name="グループ化 140">
            <a:extLst>
              <a:ext uri="{FF2B5EF4-FFF2-40B4-BE49-F238E27FC236}">
                <a16:creationId xmlns:a16="http://schemas.microsoft.com/office/drawing/2014/main" xmlns="" id="{ACC3D9A7-055D-6F55-E848-6DAA7A718123}"/>
              </a:ext>
            </a:extLst>
          </p:cNvPr>
          <p:cNvGrpSpPr/>
          <p:nvPr/>
        </p:nvGrpSpPr>
        <p:grpSpPr>
          <a:xfrm>
            <a:off x="3078980" y="2460598"/>
            <a:ext cx="1224000" cy="55146"/>
            <a:chOff x="915623" y="1104729"/>
            <a:chExt cx="1224000" cy="57321"/>
          </a:xfrm>
        </p:grpSpPr>
        <p:cxnSp>
          <p:nvCxnSpPr>
            <p:cNvPr id="142" name="直線コネクタ 141">
              <a:extLst>
                <a:ext uri="{FF2B5EF4-FFF2-40B4-BE49-F238E27FC236}">
                  <a16:creationId xmlns:a16="http://schemas.microsoft.com/office/drawing/2014/main" xmlns="" id="{7BBE4F5A-B1D2-FC98-A6BE-5C2C4D7162CA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" name="直線コネクタ 142">
              <a:extLst>
                <a:ext uri="{FF2B5EF4-FFF2-40B4-BE49-F238E27FC236}">
                  <a16:creationId xmlns:a16="http://schemas.microsoft.com/office/drawing/2014/main" xmlns="" id="{87F3AD62-16AE-AA7F-3AF8-D24E5F8FB5D1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" name="直線コネクタ 143">
              <a:extLst>
                <a:ext uri="{FF2B5EF4-FFF2-40B4-BE49-F238E27FC236}">
                  <a16:creationId xmlns:a16="http://schemas.microsoft.com/office/drawing/2014/main" xmlns="" id="{25387AEF-6041-674E-7BDC-6CD14847487E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5" name="グループ化 144">
            <a:extLst>
              <a:ext uri="{FF2B5EF4-FFF2-40B4-BE49-F238E27FC236}">
                <a16:creationId xmlns:a16="http://schemas.microsoft.com/office/drawing/2014/main" xmlns="" id="{30CC4B2A-6264-7A18-C1BF-3410E193BEA5}"/>
              </a:ext>
            </a:extLst>
          </p:cNvPr>
          <p:cNvGrpSpPr/>
          <p:nvPr/>
        </p:nvGrpSpPr>
        <p:grpSpPr>
          <a:xfrm>
            <a:off x="3502333" y="2872410"/>
            <a:ext cx="397229" cy="38399"/>
            <a:chOff x="5352044" y="5319294"/>
            <a:chExt cx="397229" cy="39913"/>
          </a:xfrm>
        </p:grpSpPr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xmlns="" id="{6B3DE385-040B-0FB4-F462-477D5C8CC9C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xmlns="" id="{20A89199-2069-2A86-040C-704D9CFD01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8" name="直線コネクタ 147">
              <a:extLst>
                <a:ext uri="{FF2B5EF4-FFF2-40B4-BE49-F238E27FC236}">
                  <a16:creationId xmlns:a16="http://schemas.microsoft.com/office/drawing/2014/main" xmlns="" id="{0A35F625-7F23-7578-F126-8EDB19F4AB41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xmlns="" id="{B1743B73-F20D-0D0F-63E8-5959A49FD674}"/>
              </a:ext>
            </a:extLst>
          </p:cNvPr>
          <p:cNvSpPr txBox="1"/>
          <p:nvPr/>
        </p:nvSpPr>
        <p:spPr>
          <a:xfrm>
            <a:off x="3206271" y="2560530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9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0" name="グループ化 149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3501539" y="2581147"/>
            <a:ext cx="793229" cy="38399"/>
            <a:chOff x="5352044" y="5319294"/>
            <a:chExt cx="793229" cy="39913"/>
          </a:xfrm>
        </p:grpSpPr>
        <p:cxnSp>
          <p:nvCxnSpPr>
            <p:cNvPr id="151" name="直線コネクタ 150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4" name="グループ化 153">
            <a:extLst>
              <a:ext uri="{FF2B5EF4-FFF2-40B4-BE49-F238E27FC236}">
                <a16:creationId xmlns:a16="http://schemas.microsoft.com/office/drawing/2014/main" xmlns="" id="{30CC4B2A-6264-7A18-C1BF-3410E193BEA5}"/>
              </a:ext>
            </a:extLst>
          </p:cNvPr>
          <p:cNvGrpSpPr/>
          <p:nvPr/>
        </p:nvGrpSpPr>
        <p:grpSpPr>
          <a:xfrm>
            <a:off x="3915990" y="2872411"/>
            <a:ext cx="397229" cy="38399"/>
            <a:chOff x="5352044" y="5319294"/>
            <a:chExt cx="397229" cy="39913"/>
          </a:xfrm>
        </p:grpSpPr>
        <p:cxnSp>
          <p:nvCxnSpPr>
            <p:cNvPr id="155" name="直線コネクタ 154">
              <a:extLst>
                <a:ext uri="{FF2B5EF4-FFF2-40B4-BE49-F238E27FC236}">
                  <a16:creationId xmlns:a16="http://schemas.microsoft.com/office/drawing/2014/main" xmlns="" id="{6B3DE385-040B-0FB4-F462-477D5C8CC9C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6" name="直線コネクタ 155">
              <a:extLst>
                <a:ext uri="{FF2B5EF4-FFF2-40B4-BE49-F238E27FC236}">
                  <a16:creationId xmlns:a16="http://schemas.microsoft.com/office/drawing/2014/main" xmlns="" id="{20A89199-2069-2A86-040C-704D9CFD01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xmlns="" id="{0A35F625-7F23-7578-F126-8EDB19F4AB41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405492" y="2268393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369205" y="270824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7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586920" y="2414619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869949" y="2701265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2" name="グループ化 161"/>
          <p:cNvGrpSpPr/>
          <p:nvPr/>
        </p:nvGrpSpPr>
        <p:grpSpPr>
          <a:xfrm>
            <a:off x="2225277" y="1259621"/>
            <a:ext cx="83464" cy="340206"/>
            <a:chOff x="5958047" y="5237259"/>
            <a:chExt cx="83464" cy="353622"/>
          </a:xfrm>
        </p:grpSpPr>
        <p:cxnSp>
          <p:nvCxnSpPr>
            <p:cNvPr id="163" name="直線コネクタ 162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40201" y="5237260"/>
              <a:ext cx="1310" cy="3367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58047" y="5589240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6" name="グループ化 165"/>
          <p:cNvGrpSpPr/>
          <p:nvPr/>
        </p:nvGrpSpPr>
        <p:grpSpPr>
          <a:xfrm>
            <a:off x="6759977" y="826744"/>
            <a:ext cx="71829" cy="344710"/>
            <a:chOff x="5971547" y="5237259"/>
            <a:chExt cx="71829" cy="358304"/>
          </a:xfrm>
        </p:grpSpPr>
        <p:cxnSp>
          <p:nvCxnSpPr>
            <p:cNvPr id="167" name="直線コネクタ 166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8" name="直線コネクタ 167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>
              <a:off x="6041511" y="5237259"/>
              <a:ext cx="1865" cy="35830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9" name="直線コネクタ 168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2333" y="5591720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0" name="グループ化 169"/>
          <p:cNvGrpSpPr/>
          <p:nvPr/>
        </p:nvGrpSpPr>
        <p:grpSpPr>
          <a:xfrm>
            <a:off x="4412058" y="2948088"/>
            <a:ext cx="81082" cy="329025"/>
            <a:chOff x="5960428" y="5237259"/>
            <a:chExt cx="81082" cy="342000"/>
          </a:xfrm>
        </p:grpSpPr>
        <p:cxnSp>
          <p:nvCxnSpPr>
            <p:cNvPr id="171" name="直線コネクタ 170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2" name="直線コネクタ 171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32265" y="5237259"/>
              <a:ext cx="9245" cy="34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60428" y="5576866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4" name="グループ化 173"/>
          <p:cNvGrpSpPr/>
          <p:nvPr/>
        </p:nvGrpSpPr>
        <p:grpSpPr>
          <a:xfrm>
            <a:off x="2283334" y="4859968"/>
            <a:ext cx="83463" cy="340206"/>
            <a:chOff x="5958047" y="5237259"/>
            <a:chExt cx="83463" cy="353622"/>
          </a:xfrm>
        </p:grpSpPr>
        <p:cxnSp>
          <p:nvCxnSpPr>
            <p:cNvPr id="175" name="直線コネクタ 174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6" name="直線コネクタ 175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32265" y="5237259"/>
              <a:ext cx="9245" cy="342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7" name="直線コネクタ 176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58047" y="5589240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8" name="グループ化 177"/>
          <p:cNvGrpSpPr/>
          <p:nvPr/>
        </p:nvGrpSpPr>
        <p:grpSpPr>
          <a:xfrm>
            <a:off x="4506287" y="4964706"/>
            <a:ext cx="73940" cy="340605"/>
            <a:chOff x="5967571" y="5237259"/>
            <a:chExt cx="73940" cy="354036"/>
          </a:xfrm>
        </p:grpSpPr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0" name="直線コネクタ 179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35665" y="5237259"/>
              <a:ext cx="5846" cy="35403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67571" y="5589234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2" name="グループ化 181"/>
          <p:cNvGrpSpPr/>
          <p:nvPr/>
        </p:nvGrpSpPr>
        <p:grpSpPr>
          <a:xfrm>
            <a:off x="8862954" y="4929784"/>
            <a:ext cx="71559" cy="344562"/>
            <a:chOff x="5969952" y="5237259"/>
            <a:chExt cx="71559" cy="358150"/>
          </a:xfrm>
        </p:grpSpPr>
        <p:cxnSp>
          <p:nvCxnSpPr>
            <p:cNvPr id="183" name="直線コネクタ 182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4" name="直線コネクタ 183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39067" y="5237259"/>
              <a:ext cx="2444" cy="35815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5" name="直線コネクタ 184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69952" y="5589243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6" name="グループ化 185"/>
          <p:cNvGrpSpPr/>
          <p:nvPr/>
        </p:nvGrpSpPr>
        <p:grpSpPr>
          <a:xfrm>
            <a:off x="6743868" y="4883455"/>
            <a:ext cx="71559" cy="333738"/>
            <a:chOff x="5969952" y="5237259"/>
            <a:chExt cx="71559" cy="346899"/>
          </a:xfrm>
        </p:grpSpPr>
        <p:cxnSp>
          <p:nvCxnSpPr>
            <p:cNvPr id="187" name="直線コネクタ 186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38840" y="5237259"/>
              <a:ext cx="2671" cy="34689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9" name="直線コネクタ 188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69952" y="5581814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0" name="グループ化 189"/>
          <p:cNvGrpSpPr/>
          <p:nvPr/>
        </p:nvGrpSpPr>
        <p:grpSpPr>
          <a:xfrm>
            <a:off x="2225277" y="3457747"/>
            <a:ext cx="83465" cy="180000"/>
            <a:chOff x="5958047" y="5237226"/>
            <a:chExt cx="83465" cy="187098"/>
          </a:xfrm>
        </p:grpSpPr>
        <p:cxnSp>
          <p:nvCxnSpPr>
            <p:cNvPr id="191" name="直線コネクタ 190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2" name="直線コネクタ 191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33058" y="5237226"/>
              <a:ext cx="8454" cy="18709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3" name="直線コネクタ 192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58047" y="542232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xmlns="" id="{D7BFD6CE-08F5-BDA8-5949-D24E3E394318}"/>
              </a:ext>
            </a:extLst>
          </p:cNvPr>
          <p:cNvSpPr txBox="1"/>
          <p:nvPr/>
        </p:nvSpPr>
        <p:spPr>
          <a:xfrm>
            <a:off x="1736366" y="1375910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xmlns="" id="{99AE5420-9B0A-5A82-7AE2-A1A245B83198}"/>
              </a:ext>
            </a:extLst>
          </p:cNvPr>
          <p:cNvSpPr txBox="1"/>
          <p:nvPr/>
        </p:nvSpPr>
        <p:spPr>
          <a:xfrm>
            <a:off x="6246357" y="935712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1830691" y="3622865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920751" y="302940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30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xmlns="" id="{076931A7-FFD7-C5F3-1695-7C86498812B6}"/>
              </a:ext>
            </a:extLst>
          </p:cNvPr>
          <p:cNvSpPr txBox="1"/>
          <p:nvPr/>
        </p:nvSpPr>
        <p:spPr>
          <a:xfrm>
            <a:off x="5446351" y="2762890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9" name="グループ化 198">
            <a:extLst>
              <a:ext uri="{FF2B5EF4-FFF2-40B4-BE49-F238E27FC236}">
                <a16:creationId xmlns:a16="http://schemas.microsoft.com/office/drawing/2014/main" xmlns="" id="{0C7DD074-80CF-3BA1-770F-4BD4E75F4BF5}"/>
              </a:ext>
            </a:extLst>
          </p:cNvPr>
          <p:cNvGrpSpPr/>
          <p:nvPr/>
        </p:nvGrpSpPr>
        <p:grpSpPr>
          <a:xfrm>
            <a:off x="5351714" y="2743821"/>
            <a:ext cx="1224000" cy="55146"/>
            <a:chOff x="915623" y="1104729"/>
            <a:chExt cx="1224000" cy="57321"/>
          </a:xfrm>
        </p:grpSpPr>
        <p:cxnSp>
          <p:nvCxnSpPr>
            <p:cNvPr id="200" name="直線コネクタ 199">
              <a:extLst>
                <a:ext uri="{FF2B5EF4-FFF2-40B4-BE49-F238E27FC236}">
                  <a16:creationId xmlns:a16="http://schemas.microsoft.com/office/drawing/2014/main" xmlns="" id="{FACAB5F3-3EEB-52D3-F59A-18C16EDACFA2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1" name="直線コネクタ 200">
              <a:extLst>
                <a:ext uri="{FF2B5EF4-FFF2-40B4-BE49-F238E27FC236}">
                  <a16:creationId xmlns:a16="http://schemas.microsoft.com/office/drawing/2014/main" xmlns="" id="{E27660D7-2753-A811-82A1-54853D56E3E9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2" name="直線コネクタ 201">
              <a:extLst>
                <a:ext uri="{FF2B5EF4-FFF2-40B4-BE49-F238E27FC236}">
                  <a16:creationId xmlns:a16="http://schemas.microsoft.com/office/drawing/2014/main" xmlns="" id="{45120657-8C60-FE89-7FD6-4A8AE486BACB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3" name="グループ化 202">
            <a:extLst>
              <a:ext uri="{FF2B5EF4-FFF2-40B4-BE49-F238E27FC236}">
                <a16:creationId xmlns:a16="http://schemas.microsoft.com/office/drawing/2014/main" xmlns="" id="{7099B1A4-DAF4-601A-3F03-BC5B5779A1EB}"/>
              </a:ext>
            </a:extLst>
          </p:cNvPr>
          <p:cNvGrpSpPr/>
          <p:nvPr/>
        </p:nvGrpSpPr>
        <p:grpSpPr>
          <a:xfrm>
            <a:off x="5360348" y="2945105"/>
            <a:ext cx="793229" cy="38399"/>
            <a:chOff x="5352044" y="5319294"/>
            <a:chExt cx="793229" cy="39913"/>
          </a:xfrm>
        </p:grpSpPr>
        <p:cxnSp>
          <p:nvCxnSpPr>
            <p:cNvPr id="204" name="直線コネクタ 203">
              <a:extLst>
                <a:ext uri="{FF2B5EF4-FFF2-40B4-BE49-F238E27FC236}">
                  <a16:creationId xmlns:a16="http://schemas.microsoft.com/office/drawing/2014/main" xmlns="" id="{B9A969BB-4BF2-78DA-C1A7-F70458595494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5" name="直線コネクタ 204">
              <a:extLst>
                <a:ext uri="{FF2B5EF4-FFF2-40B4-BE49-F238E27FC236}">
                  <a16:creationId xmlns:a16="http://schemas.microsoft.com/office/drawing/2014/main" xmlns="" id="{02E568B4-013C-6993-09C6-24A4CBF0437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6" name="直線コネクタ 205">
              <a:extLst>
                <a:ext uri="{FF2B5EF4-FFF2-40B4-BE49-F238E27FC236}">
                  <a16:creationId xmlns:a16="http://schemas.microsoft.com/office/drawing/2014/main" xmlns="" id="{7AEE1B68-B29D-ABA8-E5EC-9BAF927A0432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7" name="グループ化 206">
            <a:extLst>
              <a:ext uri="{FF2B5EF4-FFF2-40B4-BE49-F238E27FC236}">
                <a16:creationId xmlns:a16="http://schemas.microsoft.com/office/drawing/2014/main" xmlns="" id="{A3F7A5B7-431B-4FC2-F4FC-AF99D4710F3C}"/>
              </a:ext>
            </a:extLst>
          </p:cNvPr>
          <p:cNvGrpSpPr/>
          <p:nvPr/>
        </p:nvGrpSpPr>
        <p:grpSpPr>
          <a:xfrm>
            <a:off x="5361111" y="3161615"/>
            <a:ext cx="397229" cy="38399"/>
            <a:chOff x="5352044" y="5319294"/>
            <a:chExt cx="397229" cy="39913"/>
          </a:xfrm>
        </p:grpSpPr>
        <p:cxnSp>
          <p:nvCxnSpPr>
            <p:cNvPr id="208" name="直線コネクタ 207">
              <a:extLst>
                <a:ext uri="{FF2B5EF4-FFF2-40B4-BE49-F238E27FC236}">
                  <a16:creationId xmlns:a16="http://schemas.microsoft.com/office/drawing/2014/main" xmlns="" id="{2FC7F7CF-10C4-BC91-DCA2-BF3F00BC8058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9" name="直線コネクタ 208">
              <a:extLst>
                <a:ext uri="{FF2B5EF4-FFF2-40B4-BE49-F238E27FC236}">
                  <a16:creationId xmlns:a16="http://schemas.microsoft.com/office/drawing/2014/main" xmlns="" id="{6CA0B797-4AF1-87E4-CAF2-6599F1D571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0" name="直線コネクタ 209">
              <a:extLst>
                <a:ext uri="{FF2B5EF4-FFF2-40B4-BE49-F238E27FC236}">
                  <a16:creationId xmlns:a16="http://schemas.microsoft.com/office/drawing/2014/main" xmlns="" id="{603B4FB1-013E-1D86-B890-F197414E5AC7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xmlns="" id="{85C920B4-5D18-CA52-04E6-80A0DBF770E9}"/>
              </a:ext>
            </a:extLst>
          </p:cNvPr>
          <p:cNvSpPr txBox="1"/>
          <p:nvPr/>
        </p:nvSpPr>
        <p:spPr>
          <a:xfrm>
            <a:off x="5699726" y="2573021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xmlns="" id="{076931A7-FFD7-C5F3-1695-7C86498812B6}"/>
              </a:ext>
            </a:extLst>
          </p:cNvPr>
          <p:cNvSpPr txBox="1"/>
          <p:nvPr/>
        </p:nvSpPr>
        <p:spPr>
          <a:xfrm>
            <a:off x="5337499" y="2987091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3" name="グループ化 212"/>
          <p:cNvGrpSpPr/>
          <p:nvPr/>
        </p:nvGrpSpPr>
        <p:grpSpPr>
          <a:xfrm>
            <a:off x="6719829" y="2815435"/>
            <a:ext cx="81082" cy="519513"/>
            <a:chOff x="5960428" y="5237259"/>
            <a:chExt cx="81082" cy="540000"/>
          </a:xfrm>
        </p:grpSpPr>
        <p:cxnSp>
          <p:nvCxnSpPr>
            <p:cNvPr id="214" name="直線コネクタ 213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5" name="直線コネクタ 214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32265" y="5237259"/>
              <a:ext cx="9245" cy="54000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6" name="直線コネクタ 215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60428" y="5773140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xmlns="" id="{85C920B4-5D18-CA52-04E6-80A0DBF770E9}"/>
              </a:ext>
            </a:extLst>
          </p:cNvPr>
          <p:cNvSpPr txBox="1"/>
          <p:nvPr/>
        </p:nvSpPr>
        <p:spPr>
          <a:xfrm>
            <a:off x="6200461" y="3047791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46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8" name="グループ化 217">
            <a:extLst>
              <a:ext uri="{FF2B5EF4-FFF2-40B4-BE49-F238E27FC236}">
                <a16:creationId xmlns:a16="http://schemas.microsoft.com/office/drawing/2014/main" xmlns="" id="{0C7DD074-80CF-3BA1-770F-4BD4E75F4BF5}"/>
              </a:ext>
            </a:extLst>
          </p:cNvPr>
          <p:cNvGrpSpPr/>
          <p:nvPr/>
        </p:nvGrpSpPr>
        <p:grpSpPr>
          <a:xfrm>
            <a:off x="7499828" y="2520404"/>
            <a:ext cx="1224000" cy="55146"/>
            <a:chOff x="915623" y="1104729"/>
            <a:chExt cx="1224000" cy="57321"/>
          </a:xfrm>
        </p:grpSpPr>
        <p:cxnSp>
          <p:nvCxnSpPr>
            <p:cNvPr id="219" name="直線コネクタ 218">
              <a:extLst>
                <a:ext uri="{FF2B5EF4-FFF2-40B4-BE49-F238E27FC236}">
                  <a16:creationId xmlns:a16="http://schemas.microsoft.com/office/drawing/2014/main" xmlns="" id="{FACAB5F3-3EEB-52D3-F59A-18C16EDACFA2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0" name="直線コネクタ 219">
              <a:extLst>
                <a:ext uri="{FF2B5EF4-FFF2-40B4-BE49-F238E27FC236}">
                  <a16:creationId xmlns:a16="http://schemas.microsoft.com/office/drawing/2014/main" xmlns="" id="{E27660D7-2753-A811-82A1-54853D56E3E9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1" name="直線コネクタ 220">
              <a:extLst>
                <a:ext uri="{FF2B5EF4-FFF2-40B4-BE49-F238E27FC236}">
                  <a16:creationId xmlns:a16="http://schemas.microsoft.com/office/drawing/2014/main" xmlns="" id="{45120657-8C60-FE89-7FD6-4A8AE486BACB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2" name="グループ化 221">
            <a:extLst>
              <a:ext uri="{FF2B5EF4-FFF2-40B4-BE49-F238E27FC236}">
                <a16:creationId xmlns:a16="http://schemas.microsoft.com/office/drawing/2014/main" xmlns="" id="{7099B1A4-DAF4-601A-3F03-BC5B5779A1EB}"/>
              </a:ext>
            </a:extLst>
          </p:cNvPr>
          <p:cNvGrpSpPr/>
          <p:nvPr/>
        </p:nvGrpSpPr>
        <p:grpSpPr>
          <a:xfrm>
            <a:off x="7508463" y="2714705"/>
            <a:ext cx="793229" cy="38399"/>
            <a:chOff x="5352044" y="5319294"/>
            <a:chExt cx="793229" cy="39913"/>
          </a:xfrm>
        </p:grpSpPr>
        <p:cxnSp>
          <p:nvCxnSpPr>
            <p:cNvPr id="223" name="直線コネクタ 222">
              <a:extLst>
                <a:ext uri="{FF2B5EF4-FFF2-40B4-BE49-F238E27FC236}">
                  <a16:creationId xmlns:a16="http://schemas.microsoft.com/office/drawing/2014/main" xmlns="" id="{B9A969BB-4BF2-78DA-C1A7-F70458595494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直線コネクタ 223">
              <a:extLst>
                <a:ext uri="{FF2B5EF4-FFF2-40B4-BE49-F238E27FC236}">
                  <a16:creationId xmlns:a16="http://schemas.microsoft.com/office/drawing/2014/main" xmlns="" id="{02E568B4-013C-6993-09C6-24A4CBF0437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直線コネクタ 224">
              <a:extLst>
                <a:ext uri="{FF2B5EF4-FFF2-40B4-BE49-F238E27FC236}">
                  <a16:creationId xmlns:a16="http://schemas.microsoft.com/office/drawing/2014/main" xmlns="" id="{7AEE1B68-B29D-ABA8-E5EC-9BAF927A0432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6" name="グループ化 225">
            <a:extLst>
              <a:ext uri="{FF2B5EF4-FFF2-40B4-BE49-F238E27FC236}">
                <a16:creationId xmlns:a16="http://schemas.microsoft.com/office/drawing/2014/main" xmlns="" id="{7099B1A4-DAF4-601A-3F03-BC5B5779A1EB}"/>
              </a:ext>
            </a:extLst>
          </p:cNvPr>
          <p:cNvGrpSpPr/>
          <p:nvPr/>
        </p:nvGrpSpPr>
        <p:grpSpPr>
          <a:xfrm>
            <a:off x="7914863" y="2903214"/>
            <a:ext cx="793229" cy="38399"/>
            <a:chOff x="5352044" y="5319294"/>
            <a:chExt cx="793229" cy="39913"/>
          </a:xfrm>
        </p:grpSpPr>
        <p:cxnSp>
          <p:nvCxnSpPr>
            <p:cNvPr id="227" name="直線コネクタ 226">
              <a:extLst>
                <a:ext uri="{FF2B5EF4-FFF2-40B4-BE49-F238E27FC236}">
                  <a16:creationId xmlns:a16="http://schemas.microsoft.com/office/drawing/2014/main" xmlns="" id="{B9A969BB-4BF2-78DA-C1A7-F70458595494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8" name="直線コネクタ 227">
              <a:extLst>
                <a:ext uri="{FF2B5EF4-FFF2-40B4-BE49-F238E27FC236}">
                  <a16:creationId xmlns:a16="http://schemas.microsoft.com/office/drawing/2014/main" xmlns="" id="{02E568B4-013C-6993-09C6-24A4CBF0437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9" name="直線コネクタ 228">
              <a:extLst>
                <a:ext uri="{FF2B5EF4-FFF2-40B4-BE49-F238E27FC236}">
                  <a16:creationId xmlns:a16="http://schemas.microsoft.com/office/drawing/2014/main" xmlns="" id="{7AEE1B68-B29D-ABA8-E5EC-9BAF927A0432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0" name="グループ化 229">
            <a:extLst>
              <a:ext uri="{FF2B5EF4-FFF2-40B4-BE49-F238E27FC236}">
                <a16:creationId xmlns:a16="http://schemas.microsoft.com/office/drawing/2014/main" xmlns="" id="{A3F7A5B7-431B-4FC2-F4FC-AF99D4710F3C}"/>
              </a:ext>
            </a:extLst>
          </p:cNvPr>
          <p:cNvGrpSpPr/>
          <p:nvPr/>
        </p:nvGrpSpPr>
        <p:grpSpPr>
          <a:xfrm>
            <a:off x="8307511" y="2714778"/>
            <a:ext cx="397229" cy="38399"/>
            <a:chOff x="5352044" y="5319294"/>
            <a:chExt cx="397229" cy="39913"/>
          </a:xfrm>
        </p:grpSpPr>
        <p:cxnSp>
          <p:nvCxnSpPr>
            <p:cNvPr id="231" name="直線コネクタ 230">
              <a:extLst>
                <a:ext uri="{FF2B5EF4-FFF2-40B4-BE49-F238E27FC236}">
                  <a16:creationId xmlns:a16="http://schemas.microsoft.com/office/drawing/2014/main" xmlns="" id="{2FC7F7CF-10C4-BC91-DCA2-BF3F00BC8058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2" name="直線コネクタ 231">
              <a:extLst>
                <a:ext uri="{FF2B5EF4-FFF2-40B4-BE49-F238E27FC236}">
                  <a16:creationId xmlns:a16="http://schemas.microsoft.com/office/drawing/2014/main" xmlns="" id="{6CA0B797-4AF1-87E4-CAF2-6599F1D571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直線コネクタ 232">
              <a:extLst>
                <a:ext uri="{FF2B5EF4-FFF2-40B4-BE49-F238E27FC236}">
                  <a16:creationId xmlns:a16="http://schemas.microsoft.com/office/drawing/2014/main" xmlns="" id="{603B4FB1-013E-1D86-B890-F197414E5AC7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xmlns="" id="{076931A7-FFD7-C5F3-1695-7C86498812B6}"/>
              </a:ext>
            </a:extLst>
          </p:cNvPr>
          <p:cNvSpPr txBox="1"/>
          <p:nvPr/>
        </p:nvSpPr>
        <p:spPr>
          <a:xfrm>
            <a:off x="8022642" y="2721783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xmlns="" id="{076931A7-FFD7-C5F3-1695-7C86498812B6}"/>
              </a:ext>
            </a:extLst>
          </p:cNvPr>
          <p:cNvSpPr txBox="1"/>
          <p:nvPr/>
        </p:nvSpPr>
        <p:spPr>
          <a:xfrm>
            <a:off x="7579956" y="252550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xmlns="" id="{076931A7-FFD7-C5F3-1695-7C86498812B6}"/>
              </a:ext>
            </a:extLst>
          </p:cNvPr>
          <p:cNvSpPr txBox="1"/>
          <p:nvPr/>
        </p:nvSpPr>
        <p:spPr>
          <a:xfrm>
            <a:off x="8247603" y="2525510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xmlns="" id="{076931A7-FFD7-C5F3-1695-7C86498812B6}"/>
              </a:ext>
            </a:extLst>
          </p:cNvPr>
          <p:cNvSpPr txBox="1"/>
          <p:nvPr/>
        </p:nvSpPr>
        <p:spPr>
          <a:xfrm>
            <a:off x="7768641" y="2351753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2" name="グループ化 241"/>
          <p:cNvGrpSpPr/>
          <p:nvPr/>
        </p:nvGrpSpPr>
        <p:grpSpPr>
          <a:xfrm>
            <a:off x="8804896" y="3018069"/>
            <a:ext cx="71559" cy="336995"/>
            <a:chOff x="5969952" y="5237259"/>
            <a:chExt cx="71559" cy="350284"/>
          </a:xfrm>
        </p:grpSpPr>
        <p:cxnSp>
          <p:nvCxnSpPr>
            <p:cNvPr id="243" name="直線コネクタ 242">
              <a:extLst>
                <a:ext uri="{FF2B5EF4-FFF2-40B4-BE49-F238E27FC236}">
                  <a16:creationId xmlns:a16="http://schemas.microsoft.com/office/drawing/2014/main" xmlns="" id="{665EB18A-7D27-7A0B-700E-C84F0F78AB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71547" y="5237259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4" name="直線コネクタ 243">
              <a:extLst>
                <a:ext uri="{FF2B5EF4-FFF2-40B4-BE49-F238E27FC236}">
                  <a16:creationId xmlns:a16="http://schemas.microsoft.com/office/drawing/2014/main" xmlns="" id="{04FB386B-E79D-71EC-B8CC-718200833E75}"/>
                </a:ext>
              </a:extLst>
            </p:cNvPr>
            <p:cNvCxnSpPr/>
            <p:nvPr/>
          </p:nvCxnSpPr>
          <p:spPr>
            <a:xfrm flipH="1">
              <a:off x="6039975" y="5237259"/>
              <a:ext cx="1536" cy="35028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5" name="直線コネクタ 244">
              <a:extLst>
                <a:ext uri="{FF2B5EF4-FFF2-40B4-BE49-F238E27FC236}">
                  <a16:creationId xmlns:a16="http://schemas.microsoft.com/office/drawing/2014/main" xmlns="" id="{F2F33F26-5D1C-A3D2-F36E-2E053CE05D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69952" y="5581814"/>
              <a:ext cx="68433" cy="164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xmlns="" id="{85C920B4-5D18-CA52-04E6-80A0DBF770E9}"/>
              </a:ext>
            </a:extLst>
          </p:cNvPr>
          <p:cNvSpPr txBox="1"/>
          <p:nvPr/>
        </p:nvSpPr>
        <p:spPr>
          <a:xfrm>
            <a:off x="8290518" y="3117609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7" name="グループ化 246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954283" y="4974775"/>
            <a:ext cx="793229" cy="38399"/>
            <a:chOff x="5352044" y="5319294"/>
            <a:chExt cx="793229" cy="39913"/>
          </a:xfrm>
        </p:grpSpPr>
        <p:cxnSp>
          <p:nvCxnSpPr>
            <p:cNvPr id="248" name="直線コネクタ 247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9" name="直線コネクタ 248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0" name="直線コネクタ 249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1" name="グループ化 250">
            <a:extLst>
              <a:ext uri="{FF2B5EF4-FFF2-40B4-BE49-F238E27FC236}">
                <a16:creationId xmlns:a16="http://schemas.microsoft.com/office/drawing/2014/main" xmlns="" id="{ACC3D9A7-055D-6F55-E848-6DAA7A718123}"/>
              </a:ext>
            </a:extLst>
          </p:cNvPr>
          <p:cNvGrpSpPr/>
          <p:nvPr/>
        </p:nvGrpSpPr>
        <p:grpSpPr>
          <a:xfrm>
            <a:off x="930865" y="4609865"/>
            <a:ext cx="1224000" cy="55146"/>
            <a:chOff x="915623" y="1104729"/>
            <a:chExt cx="1224000" cy="57321"/>
          </a:xfrm>
        </p:grpSpPr>
        <p:cxnSp>
          <p:nvCxnSpPr>
            <p:cNvPr id="252" name="直線コネクタ 251">
              <a:extLst>
                <a:ext uri="{FF2B5EF4-FFF2-40B4-BE49-F238E27FC236}">
                  <a16:creationId xmlns:a16="http://schemas.microsoft.com/office/drawing/2014/main" xmlns="" id="{7BBE4F5A-B1D2-FC98-A6BE-5C2C4D7162CA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3" name="直線コネクタ 252">
              <a:extLst>
                <a:ext uri="{FF2B5EF4-FFF2-40B4-BE49-F238E27FC236}">
                  <a16:creationId xmlns:a16="http://schemas.microsoft.com/office/drawing/2014/main" xmlns="" id="{87F3AD62-16AE-AA7F-3AF8-D24E5F8FB5D1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4" name="直線コネクタ 253">
              <a:extLst>
                <a:ext uri="{FF2B5EF4-FFF2-40B4-BE49-F238E27FC236}">
                  <a16:creationId xmlns:a16="http://schemas.microsoft.com/office/drawing/2014/main" xmlns="" id="{25387AEF-6041-674E-7BDC-6CD14847487E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5" name="グループ化 254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1367940" y="4793247"/>
            <a:ext cx="793229" cy="38399"/>
            <a:chOff x="5352044" y="5319294"/>
            <a:chExt cx="793229" cy="39913"/>
          </a:xfrm>
        </p:grpSpPr>
        <p:cxnSp>
          <p:nvCxnSpPr>
            <p:cNvPr id="256" name="直線コネクタ 255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7" name="直線コネクタ 256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8" name="直線コネクタ 257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1046920" y="4794676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6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1235606" y="4424639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1496863" y="4620131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39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1794406" y="4983185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0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3" name="グループ化 262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3124169" y="4918923"/>
            <a:ext cx="793229" cy="38399"/>
            <a:chOff x="5352044" y="5319294"/>
            <a:chExt cx="793229" cy="39913"/>
          </a:xfrm>
        </p:grpSpPr>
        <p:cxnSp>
          <p:nvCxnSpPr>
            <p:cNvPr id="264" name="直線コネクタ 263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5" name="直線コネクタ 264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6" name="直線コネクタ 265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7" name="グループ化 266">
            <a:extLst>
              <a:ext uri="{FF2B5EF4-FFF2-40B4-BE49-F238E27FC236}">
                <a16:creationId xmlns:a16="http://schemas.microsoft.com/office/drawing/2014/main" xmlns="" id="{ACC3D9A7-055D-6F55-E848-6DAA7A718123}"/>
              </a:ext>
            </a:extLst>
          </p:cNvPr>
          <p:cNvGrpSpPr/>
          <p:nvPr/>
        </p:nvGrpSpPr>
        <p:grpSpPr>
          <a:xfrm>
            <a:off x="3100751" y="4554013"/>
            <a:ext cx="1224000" cy="55146"/>
            <a:chOff x="915623" y="1104729"/>
            <a:chExt cx="1224000" cy="57321"/>
          </a:xfrm>
        </p:grpSpPr>
        <p:cxnSp>
          <p:nvCxnSpPr>
            <p:cNvPr id="268" name="直線コネクタ 267">
              <a:extLst>
                <a:ext uri="{FF2B5EF4-FFF2-40B4-BE49-F238E27FC236}">
                  <a16:creationId xmlns:a16="http://schemas.microsoft.com/office/drawing/2014/main" xmlns="" id="{7BBE4F5A-B1D2-FC98-A6BE-5C2C4D7162CA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9" name="直線コネクタ 268">
              <a:extLst>
                <a:ext uri="{FF2B5EF4-FFF2-40B4-BE49-F238E27FC236}">
                  <a16:creationId xmlns:a16="http://schemas.microsoft.com/office/drawing/2014/main" xmlns="" id="{87F3AD62-16AE-AA7F-3AF8-D24E5F8FB5D1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0" name="直線コネクタ 269">
              <a:extLst>
                <a:ext uri="{FF2B5EF4-FFF2-40B4-BE49-F238E27FC236}">
                  <a16:creationId xmlns:a16="http://schemas.microsoft.com/office/drawing/2014/main" xmlns="" id="{25387AEF-6041-674E-7BDC-6CD14847487E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71" name="グループ化 270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3537826" y="4737396"/>
            <a:ext cx="793229" cy="38399"/>
            <a:chOff x="5352044" y="5319294"/>
            <a:chExt cx="793229" cy="39913"/>
          </a:xfrm>
        </p:grpSpPr>
        <p:cxnSp>
          <p:nvCxnSpPr>
            <p:cNvPr id="272" name="直線コネクタ 271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3" name="直線コネクタ 272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4" name="直線コネクタ 273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75" name="テキスト ボックス 274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216806" y="4738824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405492" y="436878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テキスト ボックス 276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666749" y="4564279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8" name="グループ化 277">
            <a:extLst>
              <a:ext uri="{FF2B5EF4-FFF2-40B4-BE49-F238E27FC236}">
                <a16:creationId xmlns:a16="http://schemas.microsoft.com/office/drawing/2014/main" xmlns="" id="{30CC4B2A-6264-7A18-C1BF-3410E193BEA5}"/>
              </a:ext>
            </a:extLst>
          </p:cNvPr>
          <p:cNvGrpSpPr/>
          <p:nvPr/>
        </p:nvGrpSpPr>
        <p:grpSpPr>
          <a:xfrm>
            <a:off x="3945018" y="4916948"/>
            <a:ext cx="397229" cy="38399"/>
            <a:chOff x="5352044" y="5319294"/>
            <a:chExt cx="397229" cy="39913"/>
          </a:xfrm>
        </p:grpSpPr>
        <p:cxnSp>
          <p:nvCxnSpPr>
            <p:cNvPr id="279" name="直線コネクタ 278">
              <a:extLst>
                <a:ext uri="{FF2B5EF4-FFF2-40B4-BE49-F238E27FC236}">
                  <a16:creationId xmlns:a16="http://schemas.microsoft.com/office/drawing/2014/main" xmlns="" id="{6B3DE385-040B-0FB4-F462-477D5C8CC9C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0" name="直線コネクタ 279">
              <a:extLst>
                <a:ext uri="{FF2B5EF4-FFF2-40B4-BE49-F238E27FC236}">
                  <a16:creationId xmlns:a16="http://schemas.microsoft.com/office/drawing/2014/main" xmlns="" id="{20A89199-2069-2A86-040C-704D9CFD01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1" name="直線コネクタ 280">
              <a:extLst>
                <a:ext uri="{FF2B5EF4-FFF2-40B4-BE49-F238E27FC236}">
                  <a16:creationId xmlns:a16="http://schemas.microsoft.com/office/drawing/2014/main" xmlns="" id="{0A35F625-7F23-7578-F126-8EDB19F4AB41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82" name="テキスト ボックス 281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855434" y="4731843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3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テキスト ボックス 282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3964291" y="505300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84" name="グループ化 283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5359369" y="4758342"/>
            <a:ext cx="793229" cy="38399"/>
            <a:chOff x="5352044" y="5319294"/>
            <a:chExt cx="793229" cy="39913"/>
          </a:xfrm>
        </p:grpSpPr>
        <p:cxnSp>
          <p:nvCxnSpPr>
            <p:cNvPr id="285" name="直線コネクタ 284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6" name="直線コネクタ 285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7" name="直線コネクタ 286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88" name="グループ化 287">
            <a:extLst>
              <a:ext uri="{FF2B5EF4-FFF2-40B4-BE49-F238E27FC236}">
                <a16:creationId xmlns:a16="http://schemas.microsoft.com/office/drawing/2014/main" xmlns="" id="{ACC3D9A7-055D-6F55-E848-6DAA7A718123}"/>
              </a:ext>
            </a:extLst>
          </p:cNvPr>
          <p:cNvGrpSpPr/>
          <p:nvPr/>
        </p:nvGrpSpPr>
        <p:grpSpPr>
          <a:xfrm>
            <a:off x="5335951" y="4393432"/>
            <a:ext cx="1224000" cy="55146"/>
            <a:chOff x="915623" y="1104729"/>
            <a:chExt cx="1224000" cy="57321"/>
          </a:xfrm>
        </p:grpSpPr>
        <p:cxnSp>
          <p:nvCxnSpPr>
            <p:cNvPr id="289" name="直線コネクタ 288">
              <a:extLst>
                <a:ext uri="{FF2B5EF4-FFF2-40B4-BE49-F238E27FC236}">
                  <a16:creationId xmlns:a16="http://schemas.microsoft.com/office/drawing/2014/main" xmlns="" id="{7BBE4F5A-B1D2-FC98-A6BE-5C2C4D7162CA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0" name="直線コネクタ 289">
              <a:extLst>
                <a:ext uri="{FF2B5EF4-FFF2-40B4-BE49-F238E27FC236}">
                  <a16:creationId xmlns:a16="http://schemas.microsoft.com/office/drawing/2014/main" xmlns="" id="{87F3AD62-16AE-AA7F-3AF8-D24E5F8FB5D1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1" name="直線コネクタ 290">
              <a:extLst>
                <a:ext uri="{FF2B5EF4-FFF2-40B4-BE49-F238E27FC236}">
                  <a16:creationId xmlns:a16="http://schemas.microsoft.com/office/drawing/2014/main" xmlns="" id="{25387AEF-6041-674E-7BDC-6CD14847487E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92" name="グループ化 291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5773026" y="4576814"/>
            <a:ext cx="793229" cy="38399"/>
            <a:chOff x="5352044" y="5319294"/>
            <a:chExt cx="793229" cy="39913"/>
          </a:xfrm>
        </p:grpSpPr>
        <p:cxnSp>
          <p:nvCxnSpPr>
            <p:cNvPr id="293" name="直線コネクタ 292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4" name="直線コネクタ 293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5" name="直線コネクタ 294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5452006" y="4578243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5640692" y="4208206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5901949" y="4403698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7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9" name="グループ化 298">
            <a:extLst>
              <a:ext uri="{FF2B5EF4-FFF2-40B4-BE49-F238E27FC236}">
                <a16:creationId xmlns:a16="http://schemas.microsoft.com/office/drawing/2014/main" xmlns="" id="{30CC4B2A-6264-7A18-C1BF-3410E193BEA5}"/>
              </a:ext>
            </a:extLst>
          </p:cNvPr>
          <p:cNvGrpSpPr/>
          <p:nvPr/>
        </p:nvGrpSpPr>
        <p:grpSpPr>
          <a:xfrm>
            <a:off x="6180218" y="4756366"/>
            <a:ext cx="397229" cy="38399"/>
            <a:chOff x="5352044" y="5319294"/>
            <a:chExt cx="397229" cy="39913"/>
          </a:xfrm>
        </p:grpSpPr>
        <p:cxnSp>
          <p:nvCxnSpPr>
            <p:cNvPr id="300" name="直線コネクタ 299">
              <a:extLst>
                <a:ext uri="{FF2B5EF4-FFF2-40B4-BE49-F238E27FC236}">
                  <a16:creationId xmlns:a16="http://schemas.microsoft.com/office/drawing/2014/main" xmlns="" id="{6B3DE385-040B-0FB4-F462-477D5C8CC9C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1" name="直線コネクタ 300">
              <a:extLst>
                <a:ext uri="{FF2B5EF4-FFF2-40B4-BE49-F238E27FC236}">
                  <a16:creationId xmlns:a16="http://schemas.microsoft.com/office/drawing/2014/main" xmlns="" id="{20A89199-2069-2A86-040C-704D9CFD01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2" name="直線コネクタ 301">
              <a:extLst>
                <a:ext uri="{FF2B5EF4-FFF2-40B4-BE49-F238E27FC236}">
                  <a16:creationId xmlns:a16="http://schemas.microsoft.com/office/drawing/2014/main" xmlns="" id="{0A35F625-7F23-7578-F126-8EDB19F4AB41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6221262" y="4976207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12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6112407" y="4578244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4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5" name="グループ化 304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7514740" y="4877032"/>
            <a:ext cx="793229" cy="38399"/>
            <a:chOff x="5352044" y="5319294"/>
            <a:chExt cx="793229" cy="39913"/>
          </a:xfrm>
        </p:grpSpPr>
        <p:cxnSp>
          <p:nvCxnSpPr>
            <p:cNvPr id="306" name="直線コネクタ 305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7" name="直線コネクタ 306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8" name="直線コネクタ 307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09" name="グループ化 308">
            <a:extLst>
              <a:ext uri="{FF2B5EF4-FFF2-40B4-BE49-F238E27FC236}">
                <a16:creationId xmlns:a16="http://schemas.microsoft.com/office/drawing/2014/main" xmlns="" id="{ACC3D9A7-055D-6F55-E848-6DAA7A718123}"/>
              </a:ext>
            </a:extLst>
          </p:cNvPr>
          <p:cNvGrpSpPr/>
          <p:nvPr/>
        </p:nvGrpSpPr>
        <p:grpSpPr>
          <a:xfrm>
            <a:off x="7455037" y="4512122"/>
            <a:ext cx="1224000" cy="55146"/>
            <a:chOff x="915623" y="1104729"/>
            <a:chExt cx="1224000" cy="57321"/>
          </a:xfrm>
        </p:grpSpPr>
        <p:cxnSp>
          <p:nvCxnSpPr>
            <p:cNvPr id="310" name="直線コネクタ 309">
              <a:extLst>
                <a:ext uri="{FF2B5EF4-FFF2-40B4-BE49-F238E27FC236}">
                  <a16:creationId xmlns:a16="http://schemas.microsoft.com/office/drawing/2014/main" xmlns="" id="{7BBE4F5A-B1D2-FC98-A6BE-5C2C4D7162CA}"/>
                </a:ext>
              </a:extLst>
            </p:cNvPr>
            <p:cNvCxnSpPr/>
            <p:nvPr/>
          </p:nvCxnSpPr>
          <p:spPr>
            <a:xfrm flipH="1">
              <a:off x="916774" y="1106041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1" name="直線コネクタ 310">
              <a:extLst>
                <a:ext uri="{FF2B5EF4-FFF2-40B4-BE49-F238E27FC236}">
                  <a16:creationId xmlns:a16="http://schemas.microsoft.com/office/drawing/2014/main" xmlns="" id="{87F3AD62-16AE-AA7F-3AF8-D24E5F8FB5D1}"/>
                </a:ext>
              </a:extLst>
            </p:cNvPr>
            <p:cNvCxnSpPr>
              <a:cxnSpLocks/>
            </p:cNvCxnSpPr>
            <p:nvPr/>
          </p:nvCxnSpPr>
          <p:spPr>
            <a:xfrm>
              <a:off x="2138669" y="1106041"/>
              <a:ext cx="0" cy="5600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2" name="直線コネクタ 311">
              <a:extLst>
                <a:ext uri="{FF2B5EF4-FFF2-40B4-BE49-F238E27FC236}">
                  <a16:creationId xmlns:a16="http://schemas.microsoft.com/office/drawing/2014/main" xmlns="" id="{25387AEF-6041-674E-7BDC-6CD14847487E}"/>
                </a:ext>
              </a:extLst>
            </p:cNvPr>
            <p:cNvCxnSpPr/>
            <p:nvPr/>
          </p:nvCxnSpPr>
          <p:spPr>
            <a:xfrm flipV="1">
              <a:off x="915623" y="1104729"/>
              <a:ext cx="1224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13" name="グループ化 312">
            <a:extLst>
              <a:ext uri="{FF2B5EF4-FFF2-40B4-BE49-F238E27FC236}">
                <a16:creationId xmlns:a16="http://schemas.microsoft.com/office/drawing/2014/main" xmlns="" id="{3B3E3594-BFB0-E769-16A5-FCDE6C25BFD9}"/>
              </a:ext>
            </a:extLst>
          </p:cNvPr>
          <p:cNvGrpSpPr/>
          <p:nvPr/>
        </p:nvGrpSpPr>
        <p:grpSpPr>
          <a:xfrm>
            <a:off x="7892112" y="4695505"/>
            <a:ext cx="793229" cy="38399"/>
            <a:chOff x="5352044" y="5319294"/>
            <a:chExt cx="793229" cy="39913"/>
          </a:xfrm>
        </p:grpSpPr>
        <p:cxnSp>
          <p:nvCxnSpPr>
            <p:cNvPr id="314" name="直線コネクタ 313">
              <a:extLst>
                <a:ext uri="{FF2B5EF4-FFF2-40B4-BE49-F238E27FC236}">
                  <a16:creationId xmlns:a16="http://schemas.microsoft.com/office/drawing/2014/main" xmlns="" id="{4D0CF434-1049-1FB1-861C-ABEF24C2F209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5" name="直線コネクタ 314">
              <a:extLst>
                <a:ext uri="{FF2B5EF4-FFF2-40B4-BE49-F238E27FC236}">
                  <a16:creationId xmlns:a16="http://schemas.microsoft.com/office/drawing/2014/main" xmlns="" id="{0B4729E5-9223-9302-502C-3209886A62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42121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6" name="直線コネクタ 315">
              <a:extLst>
                <a:ext uri="{FF2B5EF4-FFF2-40B4-BE49-F238E27FC236}">
                  <a16:creationId xmlns:a16="http://schemas.microsoft.com/office/drawing/2014/main" xmlns="" id="{DEB56627-CD40-89DA-F522-1E808BE5D316}"/>
                </a:ext>
              </a:extLst>
            </p:cNvPr>
            <p:cNvCxnSpPr/>
            <p:nvPr/>
          </p:nvCxnSpPr>
          <p:spPr>
            <a:xfrm flipV="1">
              <a:off x="5353273" y="5319294"/>
              <a:ext cx="792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7607377" y="4696933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7759778" y="4326896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8021035" y="4522388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20" name="グループ化 319">
            <a:extLst>
              <a:ext uri="{FF2B5EF4-FFF2-40B4-BE49-F238E27FC236}">
                <a16:creationId xmlns:a16="http://schemas.microsoft.com/office/drawing/2014/main" xmlns="" id="{30CC4B2A-6264-7A18-C1BF-3410E193BEA5}"/>
              </a:ext>
            </a:extLst>
          </p:cNvPr>
          <p:cNvGrpSpPr/>
          <p:nvPr/>
        </p:nvGrpSpPr>
        <p:grpSpPr>
          <a:xfrm>
            <a:off x="8320962" y="4874895"/>
            <a:ext cx="397229" cy="38399"/>
            <a:chOff x="5352044" y="5319294"/>
            <a:chExt cx="397229" cy="39913"/>
          </a:xfrm>
        </p:grpSpPr>
        <p:cxnSp>
          <p:nvCxnSpPr>
            <p:cNvPr id="321" name="直線コネクタ 320">
              <a:extLst>
                <a:ext uri="{FF2B5EF4-FFF2-40B4-BE49-F238E27FC236}">
                  <a16:creationId xmlns:a16="http://schemas.microsoft.com/office/drawing/2014/main" xmlns="" id="{6B3DE385-040B-0FB4-F462-477D5C8CC9C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2" name="直線コネクタ 321">
              <a:extLst>
                <a:ext uri="{FF2B5EF4-FFF2-40B4-BE49-F238E27FC236}">
                  <a16:creationId xmlns:a16="http://schemas.microsoft.com/office/drawing/2014/main" xmlns="" id="{20A89199-2069-2A86-040C-704D9CFD01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3" name="直線コネクタ 322">
              <a:extLst>
                <a:ext uri="{FF2B5EF4-FFF2-40B4-BE49-F238E27FC236}">
                  <a16:creationId xmlns:a16="http://schemas.microsoft.com/office/drawing/2014/main" xmlns="" id="{0A35F625-7F23-7578-F126-8EDB19F4AB41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24" name="グループ化 323">
            <a:extLst>
              <a:ext uri="{FF2B5EF4-FFF2-40B4-BE49-F238E27FC236}">
                <a16:creationId xmlns:a16="http://schemas.microsoft.com/office/drawing/2014/main" xmlns="" id="{30CC4B2A-6264-7A18-C1BF-3410E193BEA5}"/>
              </a:ext>
            </a:extLst>
          </p:cNvPr>
          <p:cNvGrpSpPr/>
          <p:nvPr/>
        </p:nvGrpSpPr>
        <p:grpSpPr>
          <a:xfrm>
            <a:off x="7907418" y="5042622"/>
            <a:ext cx="397229" cy="38399"/>
            <a:chOff x="5352044" y="5319294"/>
            <a:chExt cx="397229" cy="39913"/>
          </a:xfrm>
        </p:grpSpPr>
        <p:cxnSp>
          <p:nvCxnSpPr>
            <p:cNvPr id="325" name="直線コネクタ 324">
              <a:extLst>
                <a:ext uri="{FF2B5EF4-FFF2-40B4-BE49-F238E27FC236}">
                  <a16:creationId xmlns:a16="http://schemas.microsoft.com/office/drawing/2014/main" xmlns="" id="{6B3DE385-040B-0FB4-F462-477D5C8CC9CB}"/>
                </a:ext>
              </a:extLst>
            </p:cNvPr>
            <p:cNvCxnSpPr/>
            <p:nvPr/>
          </p:nvCxnSpPr>
          <p:spPr>
            <a:xfrm flipH="1">
              <a:off x="5352044" y="5320606"/>
              <a:ext cx="358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6" name="直線コネクタ 325">
              <a:extLst>
                <a:ext uri="{FF2B5EF4-FFF2-40B4-BE49-F238E27FC236}">
                  <a16:creationId xmlns:a16="http://schemas.microsoft.com/office/drawing/2014/main" xmlns="" id="{20A89199-2069-2A86-040C-704D9CFD01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46827" y="5320606"/>
              <a:ext cx="72" cy="3860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7" name="直線コネクタ 326">
              <a:extLst>
                <a:ext uri="{FF2B5EF4-FFF2-40B4-BE49-F238E27FC236}">
                  <a16:creationId xmlns:a16="http://schemas.microsoft.com/office/drawing/2014/main" xmlns="" id="{0A35F625-7F23-7578-F126-8EDB19F4AB41}"/>
                </a:ext>
              </a:extLst>
            </p:cNvPr>
            <p:cNvCxnSpPr/>
            <p:nvPr/>
          </p:nvCxnSpPr>
          <p:spPr>
            <a:xfrm flipV="1">
              <a:off x="5353273" y="5319294"/>
              <a:ext cx="396000" cy="131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8" name="テキスト ボックス 327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8224235" y="4689952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7796064" y="4871479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9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xmlns="" id="{6F23DD8F-C09E-6640-E934-0B6F577DDB78}"/>
              </a:ext>
            </a:extLst>
          </p:cNvPr>
          <p:cNvSpPr txBox="1"/>
          <p:nvPr/>
        </p:nvSpPr>
        <p:spPr>
          <a:xfrm>
            <a:off x="8311321" y="5032061"/>
            <a:ext cx="6254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>
                <a:latin typeface="Times New Roman" panose="02020603050405020304" pitchFamily="18" charset="0"/>
                <a:cs typeface="Times New Roman" panose="02020603050405020304" pitchFamily="18" charset="0"/>
              </a:rPr>
              <a:t>p=0.020*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49B30916-F959-3EF4-2B04-FECB70B65671}"/>
              </a:ext>
            </a:extLst>
          </p:cNvPr>
          <p:cNvSpPr txBox="1"/>
          <p:nvPr/>
        </p:nvSpPr>
        <p:spPr>
          <a:xfrm>
            <a:off x="14288" y="6162759"/>
            <a:ext cx="9144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ngitudinal</a:t>
            </a:r>
            <a:r>
              <a:rPr lang="en-US" altLang="ja-JP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[</a:t>
            </a:r>
            <a:r>
              <a:rPr lang="en-US" altLang="ja-JP" sz="11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]DPA713 BP</a:t>
            </a:r>
            <a:r>
              <a:rPr lang="en-US" altLang="ja-JP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 </a:t>
            </a:r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in both PD groups based on automated ROI analyses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onisamide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, significant increases in [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]DPA713 B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s were found in the whole brain (all ROIs),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ns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ilateral thalamus, caudate,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tamen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ucleus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ambens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cuneus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emporal cortex, parietal cortex, occipital cortex, and middle frontal cortex; these changes were not found in the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onisamide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. The [</a:t>
            </a:r>
            <a:r>
              <a:rPr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]DPA713 B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 at the fourth scan showed a significant difference between groups.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BDD95700-0C6F-99BE-DF5D-4D1F8C6B08FB}"/>
              </a:ext>
            </a:extLst>
          </p:cNvPr>
          <p:cNvSpPr txBox="1"/>
          <p:nvPr/>
        </p:nvSpPr>
        <p:spPr>
          <a:xfrm>
            <a:off x="7072792" y="6021087"/>
            <a:ext cx="17427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 with 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onisamide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xmlns="" id="{0D289FDC-57B9-3366-6EE9-A7D7F6A347CC}"/>
              </a:ext>
            </a:extLst>
          </p:cNvPr>
          <p:cNvSpPr txBox="1"/>
          <p:nvPr/>
        </p:nvSpPr>
        <p:spPr>
          <a:xfrm>
            <a:off x="7079920" y="5859664"/>
            <a:ext cx="19062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 without 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onisamide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xmlns="" id="{DD21DEA2-3D80-1ED9-EE0C-344BAD98867D}"/>
              </a:ext>
            </a:extLst>
          </p:cNvPr>
          <p:cNvSpPr txBox="1"/>
          <p:nvPr/>
        </p:nvSpPr>
        <p:spPr>
          <a:xfrm>
            <a:off x="6029428" y="5941244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:p&lt;0.05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CB683A90-5324-5055-65CA-D7E0D94EDB00}"/>
              </a:ext>
            </a:extLst>
          </p:cNvPr>
          <p:cNvSpPr txBox="1"/>
          <p:nvPr/>
        </p:nvSpPr>
        <p:spPr>
          <a:xfrm rot="16200000">
            <a:off x="-333022" y="932489"/>
            <a:ext cx="1423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]DPA713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A14DFC96-AB90-614E-D945-1E36AF1BE7DC}"/>
              </a:ext>
            </a:extLst>
          </p:cNvPr>
          <p:cNvSpPr txBox="1"/>
          <p:nvPr/>
        </p:nvSpPr>
        <p:spPr>
          <a:xfrm rot="16200000">
            <a:off x="-352664" y="2775257"/>
            <a:ext cx="1423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]DPA713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4726DDE3-E5A0-53CF-DBBC-47F59DD02289}"/>
              </a:ext>
            </a:extLst>
          </p:cNvPr>
          <p:cNvSpPr txBox="1"/>
          <p:nvPr/>
        </p:nvSpPr>
        <p:spPr>
          <a:xfrm rot="16200000">
            <a:off x="-350351" y="4602668"/>
            <a:ext cx="1423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kumimoji="1"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]DPA713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1" name="Picture 2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6765225" y="5893549"/>
            <a:ext cx="343920" cy="36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32" name="正方形/長方形 331">
            <a:extLst>
              <a:ext uri="{FF2B5EF4-FFF2-40B4-BE49-F238E27FC236}">
                <a16:creationId xmlns:a16="http://schemas.microsoft.com/office/drawing/2014/main" xmlns="" id="{BDCFD05C-5D7B-D63B-30CC-7C65116145CE}"/>
              </a:ext>
            </a:extLst>
          </p:cNvPr>
          <p:cNvSpPr/>
          <p:nvPr/>
        </p:nvSpPr>
        <p:spPr>
          <a:xfrm>
            <a:off x="6920553" y="6109573"/>
            <a:ext cx="45719" cy="55584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3" name="楕円 130">
            <a:extLst>
              <a:ext uri="{FF2B5EF4-FFF2-40B4-BE49-F238E27FC236}">
                <a16:creationId xmlns:a16="http://schemas.microsoft.com/office/drawing/2014/main" xmlns="" id="{74BA5CC8-EBB5-E8C9-1ADE-C826E249486E}"/>
              </a:ext>
            </a:extLst>
          </p:cNvPr>
          <p:cNvSpPr/>
          <p:nvPr/>
        </p:nvSpPr>
        <p:spPr>
          <a:xfrm>
            <a:off x="6920553" y="5951269"/>
            <a:ext cx="45719" cy="55584"/>
          </a:xfrm>
          <a:prstGeom prst="ellips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1ADAB70A-24A6-4931-5354-055FCDD5557C}"/>
              </a:ext>
            </a:extLst>
          </p:cNvPr>
          <p:cNvSpPr txBox="1"/>
          <p:nvPr/>
        </p:nvSpPr>
        <p:spPr>
          <a:xfrm>
            <a:off x="2648084" y="5651765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 line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st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xmlns="" id="{205A2DF3-2B68-05CB-BB9D-7DFDFFC19AD4}"/>
              </a:ext>
            </a:extLst>
          </p:cNvPr>
          <p:cNvSpPr txBox="1"/>
          <p:nvPr/>
        </p:nvSpPr>
        <p:spPr>
          <a:xfrm>
            <a:off x="3111489" y="5651765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year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nd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xmlns="" id="{CC315E53-CA1F-A31B-8254-F221FECA482F}"/>
              </a:ext>
            </a:extLst>
          </p:cNvPr>
          <p:cNvSpPr txBox="1"/>
          <p:nvPr/>
        </p:nvSpPr>
        <p:spPr>
          <a:xfrm>
            <a:off x="3660886" y="5651765"/>
            <a:ext cx="6270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rs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rd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50E49FEE-CB45-4BB4-33D4-CD23ACC1193B}"/>
              </a:ext>
            </a:extLst>
          </p:cNvPr>
          <p:cNvSpPr txBox="1"/>
          <p:nvPr/>
        </p:nvSpPr>
        <p:spPr>
          <a:xfrm>
            <a:off x="4218208" y="5651765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r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th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xmlns="" id="{342C9768-8DE8-041B-6CD3-6FA96DFE5998}"/>
              </a:ext>
            </a:extLst>
          </p:cNvPr>
          <p:cNvSpPr txBox="1"/>
          <p:nvPr/>
        </p:nvSpPr>
        <p:spPr>
          <a:xfrm>
            <a:off x="4922266" y="5640939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 line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st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xmlns="" id="{8BE53208-82E1-1ABC-347E-D95E5F847598}"/>
              </a:ext>
            </a:extLst>
          </p:cNvPr>
          <p:cNvSpPr txBox="1"/>
          <p:nvPr/>
        </p:nvSpPr>
        <p:spPr>
          <a:xfrm>
            <a:off x="5385671" y="5640939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year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nd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xmlns="" id="{32FF24FE-3CAD-3332-240C-16BE0531ABB4}"/>
              </a:ext>
            </a:extLst>
          </p:cNvPr>
          <p:cNvSpPr txBox="1"/>
          <p:nvPr/>
        </p:nvSpPr>
        <p:spPr>
          <a:xfrm>
            <a:off x="5935068" y="5640939"/>
            <a:ext cx="6270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rs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rd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xmlns="" id="{B9FF6DD0-08BB-5BAC-6216-CB0926ECA219}"/>
              </a:ext>
            </a:extLst>
          </p:cNvPr>
          <p:cNvSpPr txBox="1"/>
          <p:nvPr/>
        </p:nvSpPr>
        <p:spPr>
          <a:xfrm>
            <a:off x="6492390" y="5640939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r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th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xmlns="" id="{630C87B1-5E05-0D81-34D6-23C143076580}"/>
              </a:ext>
            </a:extLst>
          </p:cNvPr>
          <p:cNvSpPr txBox="1"/>
          <p:nvPr/>
        </p:nvSpPr>
        <p:spPr>
          <a:xfrm>
            <a:off x="489090" y="5640939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 line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st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xmlns="" id="{995116AA-2C28-C689-F148-50A073AE2824}"/>
              </a:ext>
            </a:extLst>
          </p:cNvPr>
          <p:cNvSpPr txBox="1"/>
          <p:nvPr/>
        </p:nvSpPr>
        <p:spPr>
          <a:xfrm>
            <a:off x="952495" y="5640939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year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nd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xmlns="" id="{C735F40F-8990-5057-041B-8EC6BA108673}"/>
              </a:ext>
            </a:extLst>
          </p:cNvPr>
          <p:cNvSpPr txBox="1"/>
          <p:nvPr/>
        </p:nvSpPr>
        <p:spPr>
          <a:xfrm>
            <a:off x="1501892" y="5640939"/>
            <a:ext cx="6270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rs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rd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xmlns="" id="{8AFC1A90-C26C-EEF6-145F-F0CA1944FAF8}"/>
              </a:ext>
            </a:extLst>
          </p:cNvPr>
          <p:cNvSpPr txBox="1"/>
          <p:nvPr/>
        </p:nvSpPr>
        <p:spPr>
          <a:xfrm>
            <a:off x="2059214" y="5640939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r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th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xmlns="" id="{32D906D0-5B2B-9C55-4DDC-E3CE9F0D60DE}"/>
              </a:ext>
            </a:extLst>
          </p:cNvPr>
          <p:cNvSpPr txBox="1"/>
          <p:nvPr/>
        </p:nvSpPr>
        <p:spPr>
          <a:xfrm>
            <a:off x="7024124" y="5641669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 line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st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xmlns="" id="{DF33C347-3DC5-E5BD-C042-390D570DE180}"/>
              </a:ext>
            </a:extLst>
          </p:cNvPr>
          <p:cNvSpPr txBox="1"/>
          <p:nvPr/>
        </p:nvSpPr>
        <p:spPr>
          <a:xfrm>
            <a:off x="7487529" y="5641669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year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nd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xmlns="" id="{2E251B14-DE5B-75DB-2512-026708657F46}"/>
              </a:ext>
            </a:extLst>
          </p:cNvPr>
          <p:cNvSpPr txBox="1"/>
          <p:nvPr/>
        </p:nvSpPr>
        <p:spPr>
          <a:xfrm>
            <a:off x="8036926" y="5641669"/>
            <a:ext cx="6270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rs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rd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xmlns="" id="{7A09BE39-1386-7682-FA32-7D68AFA9AF65}"/>
              </a:ext>
            </a:extLst>
          </p:cNvPr>
          <p:cNvSpPr txBox="1"/>
          <p:nvPr/>
        </p:nvSpPr>
        <p:spPr>
          <a:xfrm>
            <a:off x="8594248" y="5641669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r later</a:t>
            </a:r>
          </a:p>
          <a:p>
            <a:r>
              <a:rPr lang="en-US" altLang="ja-JP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th scan)</a:t>
            </a:r>
            <a:endParaRPr kumimoji="1" lang="ja-JP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xmlns="" id="{49B30916-F959-3EF4-2B04-FECB70B65671}"/>
              </a:ext>
            </a:extLst>
          </p:cNvPr>
          <p:cNvSpPr txBox="1"/>
          <p:nvPr/>
        </p:nvSpPr>
        <p:spPr>
          <a:xfrm>
            <a:off x="-29028" y="-36285"/>
            <a:ext cx="9144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US" altLang="ja-JP" sz="11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76954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5</TotalTime>
  <Words>355</Words>
  <Application>Microsoft Office PowerPoint</Application>
  <PresentationFormat>画面に合わせる (4:3)</PresentationFormat>
  <Paragraphs>10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mpmed</dc:creator>
  <cp:lastModifiedBy>TERADA Tatsuhiro</cp:lastModifiedBy>
  <cp:revision>62</cp:revision>
  <dcterms:created xsi:type="dcterms:W3CDTF">2022-06-28T05:17:12Z</dcterms:created>
  <dcterms:modified xsi:type="dcterms:W3CDTF">2024-01-24T12:34:52Z</dcterms:modified>
</cp:coreProperties>
</file>